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7102475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anna Bury" userId="0eb69649-27cb-4e1f-82d4-22f29aef5571" providerId="ADAL" clId="{72E2DFC3-2130-425E-AF91-2C796C872C89}"/>
    <pc:docChg chg="undo custSel modSld">
      <pc:chgData name="Joanna Bury" userId="0eb69649-27cb-4e1f-82d4-22f29aef5571" providerId="ADAL" clId="{72E2DFC3-2130-425E-AF91-2C796C872C89}" dt="2020-10-29T19:31:52.850" v="18" actId="6549"/>
      <pc:docMkLst>
        <pc:docMk/>
      </pc:docMkLst>
      <pc:sldChg chg="modSp mod">
        <pc:chgData name="Joanna Bury" userId="0eb69649-27cb-4e1f-82d4-22f29aef5571" providerId="ADAL" clId="{72E2DFC3-2130-425E-AF91-2C796C872C89}" dt="2020-10-29T19:31:52.850" v="18" actId="6549"/>
        <pc:sldMkLst>
          <pc:docMk/>
          <pc:sldMk cId="1247222253" sldId="267"/>
        </pc:sldMkLst>
        <pc:spChg chg="mod">
          <ac:chgData name="Joanna Bury" userId="0eb69649-27cb-4e1f-82d4-22f29aef5571" providerId="ADAL" clId="{72E2DFC3-2130-425E-AF91-2C796C872C89}" dt="2020-10-29T19:31:26.473" v="14" actId="114"/>
          <ac:spMkLst>
            <pc:docMk/>
            <pc:sldMk cId="1247222253" sldId="267"/>
            <ac:spMk id="6" creationId="{00000000-0000-0000-0000-000000000000}"/>
          </ac:spMkLst>
        </pc:spChg>
        <pc:spChg chg="mod">
          <ac:chgData name="Joanna Bury" userId="0eb69649-27cb-4e1f-82d4-22f29aef5571" providerId="ADAL" clId="{72E2DFC3-2130-425E-AF91-2C796C872C89}" dt="2020-10-29T19:31:36.449" v="16" actId="207"/>
          <ac:spMkLst>
            <pc:docMk/>
            <pc:sldMk cId="1247222253" sldId="267"/>
            <ac:spMk id="36" creationId="{00000000-0000-0000-0000-000000000000}"/>
          </ac:spMkLst>
        </pc:spChg>
        <pc:graphicFrameChg chg="modGraphic">
          <ac:chgData name="Joanna Bury" userId="0eb69649-27cb-4e1f-82d4-22f29aef5571" providerId="ADAL" clId="{72E2DFC3-2130-425E-AF91-2C796C872C89}" dt="2020-10-29T19:31:52.850" v="18" actId="6549"/>
          <ac:graphicFrameMkLst>
            <pc:docMk/>
            <pc:sldMk cId="1247222253" sldId="267"/>
            <ac:graphicFrameMk id="5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2\Fig3&#12289;1230&#8594;21022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455937096587763E-2"/>
          <c:y val="3.5724934238389384E-2"/>
          <c:w val="0.88256737090136195"/>
          <c:h val="0.76130578639302871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4!$B$428</c:f>
              <c:strCache>
                <c:ptCount val="1"/>
                <c:pt idx="0">
                  <c:v>MELD score &lt;7</c:v>
                </c:pt>
              </c:strCache>
            </c:strRef>
          </c:tx>
          <c:spPr>
            <a:ln w="28575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4!$A$429:$A$667</c:f>
              <c:numCache>
                <c:formatCode>General</c:formatCode>
                <c:ptCount val="239"/>
                <c:pt idx="0">
                  <c:v>0</c:v>
                </c:pt>
                <c:pt idx="1">
                  <c:v>6</c:v>
                </c:pt>
                <c:pt idx="2">
                  <c:v>6</c:v>
                </c:pt>
                <c:pt idx="3">
                  <c:v>22</c:v>
                </c:pt>
                <c:pt idx="4">
                  <c:v>30</c:v>
                </c:pt>
                <c:pt idx="5">
                  <c:v>41</c:v>
                </c:pt>
                <c:pt idx="6">
                  <c:v>41</c:v>
                </c:pt>
                <c:pt idx="7">
                  <c:v>44</c:v>
                </c:pt>
                <c:pt idx="8">
                  <c:v>44</c:v>
                </c:pt>
                <c:pt idx="9">
                  <c:v>51</c:v>
                </c:pt>
                <c:pt idx="10">
                  <c:v>72</c:v>
                </c:pt>
                <c:pt idx="11">
                  <c:v>72</c:v>
                </c:pt>
                <c:pt idx="12">
                  <c:v>79</c:v>
                </c:pt>
                <c:pt idx="13">
                  <c:v>79</c:v>
                </c:pt>
                <c:pt idx="14">
                  <c:v>89</c:v>
                </c:pt>
                <c:pt idx="15">
                  <c:v>89</c:v>
                </c:pt>
                <c:pt idx="16">
                  <c:v>98</c:v>
                </c:pt>
                <c:pt idx="17">
                  <c:v>98</c:v>
                </c:pt>
                <c:pt idx="18">
                  <c:v>111</c:v>
                </c:pt>
                <c:pt idx="19">
                  <c:v>111</c:v>
                </c:pt>
                <c:pt idx="20">
                  <c:v>117</c:v>
                </c:pt>
                <c:pt idx="21">
                  <c:v>143</c:v>
                </c:pt>
                <c:pt idx="22">
                  <c:v>143</c:v>
                </c:pt>
                <c:pt idx="23">
                  <c:v>150</c:v>
                </c:pt>
                <c:pt idx="24">
                  <c:v>150</c:v>
                </c:pt>
                <c:pt idx="25">
                  <c:v>181</c:v>
                </c:pt>
                <c:pt idx="26">
                  <c:v>182</c:v>
                </c:pt>
                <c:pt idx="27">
                  <c:v>188</c:v>
                </c:pt>
                <c:pt idx="28">
                  <c:v>188</c:v>
                </c:pt>
                <c:pt idx="29">
                  <c:v>245</c:v>
                </c:pt>
                <c:pt idx="30">
                  <c:v>268</c:v>
                </c:pt>
                <c:pt idx="31">
                  <c:v>275</c:v>
                </c:pt>
                <c:pt idx="32">
                  <c:v>284</c:v>
                </c:pt>
                <c:pt idx="33">
                  <c:v>284</c:v>
                </c:pt>
                <c:pt idx="34">
                  <c:v>285</c:v>
                </c:pt>
                <c:pt idx="35">
                  <c:v>285</c:v>
                </c:pt>
                <c:pt idx="36">
                  <c:v>343</c:v>
                </c:pt>
                <c:pt idx="37">
                  <c:v>343</c:v>
                </c:pt>
                <c:pt idx="38">
                  <c:v>370</c:v>
                </c:pt>
                <c:pt idx="39">
                  <c:v>370</c:v>
                </c:pt>
                <c:pt idx="40">
                  <c:v>405</c:v>
                </c:pt>
                <c:pt idx="41">
                  <c:v>405</c:v>
                </c:pt>
                <c:pt idx="42">
                  <c:v>433</c:v>
                </c:pt>
                <c:pt idx="43">
                  <c:v>433</c:v>
                </c:pt>
                <c:pt idx="44">
                  <c:v>439</c:v>
                </c:pt>
                <c:pt idx="45">
                  <c:v>478</c:v>
                </c:pt>
                <c:pt idx="46">
                  <c:v>489</c:v>
                </c:pt>
                <c:pt idx="47">
                  <c:v>503</c:v>
                </c:pt>
                <c:pt idx="48">
                  <c:v>512</c:v>
                </c:pt>
                <c:pt idx="49">
                  <c:v>521</c:v>
                </c:pt>
                <c:pt idx="50">
                  <c:v>521</c:v>
                </c:pt>
                <c:pt idx="51">
                  <c:v>527</c:v>
                </c:pt>
                <c:pt idx="52">
                  <c:v>527</c:v>
                </c:pt>
                <c:pt idx="53">
                  <c:v>541</c:v>
                </c:pt>
                <c:pt idx="54">
                  <c:v>578</c:v>
                </c:pt>
                <c:pt idx="55">
                  <c:v>578</c:v>
                </c:pt>
                <c:pt idx="56">
                  <c:v>650</c:v>
                </c:pt>
                <c:pt idx="57">
                  <c:v>650</c:v>
                </c:pt>
                <c:pt idx="58">
                  <c:v>681</c:v>
                </c:pt>
                <c:pt idx="59">
                  <c:v>693</c:v>
                </c:pt>
                <c:pt idx="60">
                  <c:v>693</c:v>
                </c:pt>
                <c:pt idx="61">
                  <c:v>717</c:v>
                </c:pt>
                <c:pt idx="62">
                  <c:v>736</c:v>
                </c:pt>
                <c:pt idx="63">
                  <c:v>736</c:v>
                </c:pt>
                <c:pt idx="64">
                  <c:v>739</c:v>
                </c:pt>
                <c:pt idx="65">
                  <c:v>739</c:v>
                </c:pt>
                <c:pt idx="66">
                  <c:v>763</c:v>
                </c:pt>
                <c:pt idx="67">
                  <c:v>763</c:v>
                </c:pt>
                <c:pt idx="68">
                  <c:v>778.70269490740611</c:v>
                </c:pt>
                <c:pt idx="69">
                  <c:v>783</c:v>
                </c:pt>
                <c:pt idx="70">
                  <c:v>784</c:v>
                </c:pt>
                <c:pt idx="71">
                  <c:v>786</c:v>
                </c:pt>
                <c:pt idx="72">
                  <c:v>786</c:v>
                </c:pt>
                <c:pt idx="73">
                  <c:v>795</c:v>
                </c:pt>
                <c:pt idx="74">
                  <c:v>795</c:v>
                </c:pt>
                <c:pt idx="75">
                  <c:v>817</c:v>
                </c:pt>
                <c:pt idx="76">
                  <c:v>817</c:v>
                </c:pt>
                <c:pt idx="77">
                  <c:v>882</c:v>
                </c:pt>
                <c:pt idx="78">
                  <c:v>882</c:v>
                </c:pt>
                <c:pt idx="79">
                  <c:v>887</c:v>
                </c:pt>
                <c:pt idx="80">
                  <c:v>887</c:v>
                </c:pt>
                <c:pt idx="81">
                  <c:v>888</c:v>
                </c:pt>
                <c:pt idx="82">
                  <c:v>888</c:v>
                </c:pt>
                <c:pt idx="83">
                  <c:v>963</c:v>
                </c:pt>
                <c:pt idx="84">
                  <c:v>963</c:v>
                </c:pt>
                <c:pt idx="85">
                  <c:v>1020</c:v>
                </c:pt>
                <c:pt idx="86">
                  <c:v>1020</c:v>
                </c:pt>
                <c:pt idx="87">
                  <c:v>1024</c:v>
                </c:pt>
                <c:pt idx="88">
                  <c:v>1024</c:v>
                </c:pt>
                <c:pt idx="89">
                  <c:v>1055</c:v>
                </c:pt>
                <c:pt idx="90">
                  <c:v>1055</c:v>
                </c:pt>
                <c:pt idx="91">
                  <c:v>1086</c:v>
                </c:pt>
                <c:pt idx="92">
                  <c:v>1086</c:v>
                </c:pt>
                <c:pt idx="93">
                  <c:v>1108</c:v>
                </c:pt>
                <c:pt idx="94">
                  <c:v>1108</c:v>
                </c:pt>
                <c:pt idx="95">
                  <c:v>1149</c:v>
                </c:pt>
                <c:pt idx="96">
                  <c:v>1149</c:v>
                </c:pt>
                <c:pt idx="97">
                  <c:v>1152</c:v>
                </c:pt>
                <c:pt idx="98">
                  <c:v>1152</c:v>
                </c:pt>
                <c:pt idx="99">
                  <c:v>1219</c:v>
                </c:pt>
                <c:pt idx="100">
                  <c:v>1219</c:v>
                </c:pt>
                <c:pt idx="101">
                  <c:v>1255</c:v>
                </c:pt>
                <c:pt idx="102">
                  <c:v>1275</c:v>
                </c:pt>
                <c:pt idx="103">
                  <c:v>1275</c:v>
                </c:pt>
                <c:pt idx="104">
                  <c:v>1302</c:v>
                </c:pt>
                <c:pt idx="105">
                  <c:v>1302</c:v>
                </c:pt>
                <c:pt idx="106">
                  <c:v>1302.7026949074061</c:v>
                </c:pt>
                <c:pt idx="107">
                  <c:v>1322</c:v>
                </c:pt>
                <c:pt idx="108">
                  <c:v>1322</c:v>
                </c:pt>
                <c:pt idx="109">
                  <c:v>1352</c:v>
                </c:pt>
                <c:pt idx="110">
                  <c:v>1352</c:v>
                </c:pt>
                <c:pt idx="111">
                  <c:v>1363</c:v>
                </c:pt>
                <c:pt idx="112">
                  <c:v>1363</c:v>
                </c:pt>
                <c:pt idx="113">
                  <c:v>1414</c:v>
                </c:pt>
                <c:pt idx="114">
                  <c:v>1414</c:v>
                </c:pt>
                <c:pt idx="115">
                  <c:v>1421</c:v>
                </c:pt>
                <c:pt idx="116">
                  <c:v>1421</c:v>
                </c:pt>
                <c:pt idx="117">
                  <c:v>1429</c:v>
                </c:pt>
                <c:pt idx="118">
                  <c:v>1429</c:v>
                </c:pt>
                <c:pt idx="119">
                  <c:v>1490</c:v>
                </c:pt>
                <c:pt idx="120">
                  <c:v>1491</c:v>
                </c:pt>
                <c:pt idx="121">
                  <c:v>1491</c:v>
                </c:pt>
                <c:pt idx="122">
                  <c:v>1554</c:v>
                </c:pt>
                <c:pt idx="123">
                  <c:v>1554</c:v>
                </c:pt>
                <c:pt idx="124">
                  <c:v>1581</c:v>
                </c:pt>
                <c:pt idx="125">
                  <c:v>1581</c:v>
                </c:pt>
                <c:pt idx="126">
                  <c:v>1584</c:v>
                </c:pt>
                <c:pt idx="127">
                  <c:v>1584</c:v>
                </c:pt>
                <c:pt idx="128">
                  <c:v>1593</c:v>
                </c:pt>
                <c:pt idx="129">
                  <c:v>1593</c:v>
                </c:pt>
                <c:pt idx="130">
                  <c:v>1617</c:v>
                </c:pt>
                <c:pt idx="131">
                  <c:v>1617</c:v>
                </c:pt>
                <c:pt idx="132">
                  <c:v>1630</c:v>
                </c:pt>
                <c:pt idx="133">
                  <c:v>1630</c:v>
                </c:pt>
                <c:pt idx="134">
                  <c:v>1719</c:v>
                </c:pt>
                <c:pt idx="135">
                  <c:v>1719</c:v>
                </c:pt>
                <c:pt idx="136">
                  <c:v>1740</c:v>
                </c:pt>
                <c:pt idx="137">
                  <c:v>1826</c:v>
                </c:pt>
                <c:pt idx="138">
                  <c:v>1826</c:v>
                </c:pt>
                <c:pt idx="139">
                  <c:v>1826.7026949074061</c:v>
                </c:pt>
                <c:pt idx="140">
                  <c:v>1832.7026949074061</c:v>
                </c:pt>
                <c:pt idx="141">
                  <c:v>1858</c:v>
                </c:pt>
                <c:pt idx="142">
                  <c:v>1858</c:v>
                </c:pt>
                <c:pt idx="143">
                  <c:v>1860</c:v>
                </c:pt>
                <c:pt idx="144">
                  <c:v>1887</c:v>
                </c:pt>
                <c:pt idx="145">
                  <c:v>1887</c:v>
                </c:pt>
                <c:pt idx="146">
                  <c:v>1904.7026949074061</c:v>
                </c:pt>
                <c:pt idx="147">
                  <c:v>1926</c:v>
                </c:pt>
                <c:pt idx="148">
                  <c:v>1926</c:v>
                </c:pt>
                <c:pt idx="149">
                  <c:v>1930.7026949074061</c:v>
                </c:pt>
                <c:pt idx="150">
                  <c:v>1940</c:v>
                </c:pt>
                <c:pt idx="151">
                  <c:v>1995</c:v>
                </c:pt>
                <c:pt idx="152">
                  <c:v>1995</c:v>
                </c:pt>
                <c:pt idx="153">
                  <c:v>2006</c:v>
                </c:pt>
                <c:pt idx="154">
                  <c:v>2006</c:v>
                </c:pt>
                <c:pt idx="155">
                  <c:v>2021</c:v>
                </c:pt>
                <c:pt idx="156">
                  <c:v>2021</c:v>
                </c:pt>
                <c:pt idx="157">
                  <c:v>2062</c:v>
                </c:pt>
                <c:pt idx="158">
                  <c:v>2065</c:v>
                </c:pt>
                <c:pt idx="159">
                  <c:v>2065</c:v>
                </c:pt>
                <c:pt idx="160">
                  <c:v>2071.7026949074061</c:v>
                </c:pt>
                <c:pt idx="161">
                  <c:v>2093.7026949074061</c:v>
                </c:pt>
                <c:pt idx="162">
                  <c:v>2105</c:v>
                </c:pt>
                <c:pt idx="163">
                  <c:v>2105</c:v>
                </c:pt>
                <c:pt idx="164">
                  <c:v>2188</c:v>
                </c:pt>
                <c:pt idx="165">
                  <c:v>2188</c:v>
                </c:pt>
                <c:pt idx="166">
                  <c:v>2224</c:v>
                </c:pt>
                <c:pt idx="167">
                  <c:v>2224</c:v>
                </c:pt>
                <c:pt idx="168">
                  <c:v>2259.7026949074061</c:v>
                </c:pt>
                <c:pt idx="169">
                  <c:v>2263</c:v>
                </c:pt>
                <c:pt idx="170">
                  <c:v>2284</c:v>
                </c:pt>
                <c:pt idx="171">
                  <c:v>2284</c:v>
                </c:pt>
                <c:pt idx="172">
                  <c:v>2322</c:v>
                </c:pt>
                <c:pt idx="173">
                  <c:v>2322</c:v>
                </c:pt>
                <c:pt idx="174">
                  <c:v>2345</c:v>
                </c:pt>
                <c:pt idx="175">
                  <c:v>2345</c:v>
                </c:pt>
                <c:pt idx="176">
                  <c:v>2405</c:v>
                </c:pt>
                <c:pt idx="177">
                  <c:v>2405</c:v>
                </c:pt>
                <c:pt idx="178">
                  <c:v>2476.7026949074061</c:v>
                </c:pt>
                <c:pt idx="179">
                  <c:v>2477</c:v>
                </c:pt>
                <c:pt idx="180">
                  <c:v>2477</c:v>
                </c:pt>
                <c:pt idx="181">
                  <c:v>2491</c:v>
                </c:pt>
                <c:pt idx="182">
                  <c:v>2491</c:v>
                </c:pt>
                <c:pt idx="183">
                  <c:v>2513</c:v>
                </c:pt>
                <c:pt idx="184">
                  <c:v>2513</c:v>
                </c:pt>
                <c:pt idx="185">
                  <c:v>2541</c:v>
                </c:pt>
                <c:pt idx="186">
                  <c:v>2541</c:v>
                </c:pt>
                <c:pt idx="187">
                  <c:v>2569</c:v>
                </c:pt>
                <c:pt idx="188">
                  <c:v>2618.7026949074061</c:v>
                </c:pt>
                <c:pt idx="189">
                  <c:v>2713</c:v>
                </c:pt>
                <c:pt idx="190">
                  <c:v>2713</c:v>
                </c:pt>
                <c:pt idx="191">
                  <c:v>2729</c:v>
                </c:pt>
                <c:pt idx="192">
                  <c:v>2772</c:v>
                </c:pt>
                <c:pt idx="193">
                  <c:v>2772</c:v>
                </c:pt>
                <c:pt idx="194">
                  <c:v>2800.7026949074061</c:v>
                </c:pt>
                <c:pt idx="195">
                  <c:v>2815</c:v>
                </c:pt>
                <c:pt idx="196">
                  <c:v>2815</c:v>
                </c:pt>
                <c:pt idx="197">
                  <c:v>2884</c:v>
                </c:pt>
                <c:pt idx="198">
                  <c:v>2884</c:v>
                </c:pt>
                <c:pt idx="199">
                  <c:v>2966.7026949074061</c:v>
                </c:pt>
                <c:pt idx="200">
                  <c:v>2988</c:v>
                </c:pt>
                <c:pt idx="201">
                  <c:v>2988</c:v>
                </c:pt>
                <c:pt idx="202">
                  <c:v>3043.7026949074061</c:v>
                </c:pt>
                <c:pt idx="203">
                  <c:v>3101.7026949074061</c:v>
                </c:pt>
                <c:pt idx="204">
                  <c:v>3113</c:v>
                </c:pt>
                <c:pt idx="205">
                  <c:v>3113</c:v>
                </c:pt>
                <c:pt idx="206">
                  <c:v>3161</c:v>
                </c:pt>
                <c:pt idx="207">
                  <c:v>3161</c:v>
                </c:pt>
                <c:pt idx="208">
                  <c:v>3175.7026949074061</c:v>
                </c:pt>
                <c:pt idx="209">
                  <c:v>3175.7026949074061</c:v>
                </c:pt>
                <c:pt idx="210">
                  <c:v>3178.7026949074061</c:v>
                </c:pt>
                <c:pt idx="211">
                  <c:v>3276.7026949074061</c:v>
                </c:pt>
                <c:pt idx="212">
                  <c:v>3343</c:v>
                </c:pt>
                <c:pt idx="213">
                  <c:v>3343</c:v>
                </c:pt>
                <c:pt idx="214">
                  <c:v>3366.7026949074061</c:v>
                </c:pt>
                <c:pt idx="215">
                  <c:v>3428</c:v>
                </c:pt>
                <c:pt idx="216">
                  <c:v>3428</c:v>
                </c:pt>
                <c:pt idx="217">
                  <c:v>3437.7026949074061</c:v>
                </c:pt>
                <c:pt idx="218">
                  <c:v>3480.7026949074061</c:v>
                </c:pt>
                <c:pt idx="219">
                  <c:v>3541.7026949074061</c:v>
                </c:pt>
                <c:pt idx="220">
                  <c:v>3575.7026949074061</c:v>
                </c:pt>
                <c:pt idx="221">
                  <c:v>3580</c:v>
                </c:pt>
                <c:pt idx="222">
                  <c:v>3580</c:v>
                </c:pt>
                <c:pt idx="223">
                  <c:v>3581.7026949074061</c:v>
                </c:pt>
                <c:pt idx="224">
                  <c:v>3654</c:v>
                </c:pt>
                <c:pt idx="225">
                  <c:v>3758</c:v>
                </c:pt>
                <c:pt idx="226">
                  <c:v>3758</c:v>
                </c:pt>
                <c:pt idx="227">
                  <c:v>3865.7026949074061</c:v>
                </c:pt>
                <c:pt idx="228">
                  <c:v>3893</c:v>
                </c:pt>
                <c:pt idx="229">
                  <c:v>3893</c:v>
                </c:pt>
                <c:pt idx="230">
                  <c:v>3915</c:v>
                </c:pt>
                <c:pt idx="231">
                  <c:v>3975</c:v>
                </c:pt>
                <c:pt idx="232">
                  <c:v>3975</c:v>
                </c:pt>
                <c:pt idx="233">
                  <c:v>4253.7026949074061</c:v>
                </c:pt>
                <c:pt idx="234">
                  <c:v>4271.7026949074061</c:v>
                </c:pt>
                <c:pt idx="235">
                  <c:v>4684.7026949074061</c:v>
                </c:pt>
                <c:pt idx="236">
                  <c:v>4760</c:v>
                </c:pt>
                <c:pt idx="237">
                  <c:v>5109.7026949074061</c:v>
                </c:pt>
                <c:pt idx="238">
                  <c:v>5405.7026949074061</c:v>
                </c:pt>
              </c:numCache>
            </c:numRef>
          </c:xVal>
          <c:yVal>
            <c:numRef>
              <c:f>Sheet4!$B$429:$B$667</c:f>
              <c:numCache>
                <c:formatCode>General</c:formatCode>
                <c:ptCount val="239"/>
                <c:pt idx="0" formatCode="0.0000">
                  <c:v>1</c:v>
                </c:pt>
                <c:pt idx="1">
                  <c:v>1</c:v>
                </c:pt>
                <c:pt idx="2" formatCode="0.0000">
                  <c:v>0.99346405228758172</c:v>
                </c:pt>
                <c:pt idx="3" formatCode="0.0000">
                  <c:v>0.99346405228758172</c:v>
                </c:pt>
                <c:pt idx="4" formatCode="0.0000">
                  <c:v>0.99346405228758172</c:v>
                </c:pt>
                <c:pt idx="5">
                  <c:v>0.99346405228758172</c:v>
                </c:pt>
                <c:pt idx="6" formatCode="0.0000">
                  <c:v>0.98684095860566445</c:v>
                </c:pt>
                <c:pt idx="7">
                  <c:v>0.98684095860566445</c:v>
                </c:pt>
                <c:pt idx="8" formatCode="0.0000">
                  <c:v>0.98017311429076126</c:v>
                </c:pt>
                <c:pt idx="9" formatCode="0.0000">
                  <c:v>0.98017311429076126</c:v>
                </c:pt>
                <c:pt idx="10">
                  <c:v>0.98017311429076126</c:v>
                </c:pt>
                <c:pt idx="11" formatCode="0.0000">
                  <c:v>0.97345959980931762</c:v>
                </c:pt>
                <c:pt idx="12">
                  <c:v>0.97345959980931762</c:v>
                </c:pt>
                <c:pt idx="13" formatCode="0.0000">
                  <c:v>0.96674608532787398</c:v>
                </c:pt>
                <c:pt idx="14">
                  <c:v>0.96674608532787398</c:v>
                </c:pt>
                <c:pt idx="15" formatCode="0.0000">
                  <c:v>0.96003257084643046</c:v>
                </c:pt>
                <c:pt idx="16">
                  <c:v>0.96003257084643046</c:v>
                </c:pt>
                <c:pt idx="17" formatCode="0.0000">
                  <c:v>0.95331905636498693</c:v>
                </c:pt>
                <c:pt idx="18">
                  <c:v>0.95331905636498693</c:v>
                </c:pt>
                <c:pt idx="19" formatCode="0.0000">
                  <c:v>0.9466055418835434</c:v>
                </c:pt>
                <c:pt idx="20" formatCode="0.0000">
                  <c:v>0.9466055418835434</c:v>
                </c:pt>
                <c:pt idx="21">
                  <c:v>0.9466055418835434</c:v>
                </c:pt>
                <c:pt idx="22" formatCode="0.0000">
                  <c:v>0.93984407372723244</c:v>
                </c:pt>
                <c:pt idx="23">
                  <c:v>0.93984407372723244</c:v>
                </c:pt>
                <c:pt idx="24" formatCode="0.0000">
                  <c:v>0.93308260557092149</c:v>
                </c:pt>
                <c:pt idx="25" formatCode="0.0000">
                  <c:v>0.93308260557092149</c:v>
                </c:pt>
                <c:pt idx="26" formatCode="0.0000">
                  <c:v>0.93308260557092149</c:v>
                </c:pt>
                <c:pt idx="27">
                  <c:v>0.93308260557092149</c:v>
                </c:pt>
                <c:pt idx="28" formatCode="0.0000">
                  <c:v>0.92622170405937065</c:v>
                </c:pt>
                <c:pt idx="29" formatCode="0.0000">
                  <c:v>0.92622170405937065</c:v>
                </c:pt>
                <c:pt idx="30" formatCode="0.0000">
                  <c:v>0.92622170405937065</c:v>
                </c:pt>
                <c:pt idx="31" formatCode="0.0000">
                  <c:v>0.92622170405937065</c:v>
                </c:pt>
                <c:pt idx="32">
                  <c:v>0.92622170405937065</c:v>
                </c:pt>
                <c:pt idx="33" formatCode="0.0000">
                  <c:v>0.91915130937189449</c:v>
                </c:pt>
                <c:pt idx="34">
                  <c:v>0.91915130937189449</c:v>
                </c:pt>
                <c:pt idx="35" formatCode="0.0000">
                  <c:v>0.91208091468441843</c:v>
                </c:pt>
                <c:pt idx="36">
                  <c:v>0.91208091468441843</c:v>
                </c:pt>
                <c:pt idx="37" formatCode="0.0000">
                  <c:v>0.90501051999694226</c:v>
                </c:pt>
                <c:pt idx="38">
                  <c:v>0.90501051999694226</c:v>
                </c:pt>
                <c:pt idx="39" formatCode="0.0000">
                  <c:v>0.8979401253094661</c:v>
                </c:pt>
                <c:pt idx="40">
                  <c:v>0.8979401253094661</c:v>
                </c:pt>
                <c:pt idx="41" formatCode="0.0000">
                  <c:v>0.89086973062199004</c:v>
                </c:pt>
                <c:pt idx="42">
                  <c:v>0.89086973062199004</c:v>
                </c:pt>
                <c:pt idx="43" formatCode="0.0000">
                  <c:v>0.88374277277701407</c:v>
                </c:pt>
                <c:pt idx="44" formatCode="0.0000">
                  <c:v>0.88374277277701407</c:v>
                </c:pt>
                <c:pt idx="45" formatCode="0.0000">
                  <c:v>0.88374277277701407</c:v>
                </c:pt>
                <c:pt idx="46" formatCode="0.0000">
                  <c:v>0.88374277277701407</c:v>
                </c:pt>
                <c:pt idx="47" formatCode="0.0000">
                  <c:v>0.88374277277701407</c:v>
                </c:pt>
                <c:pt idx="48" formatCode="0.0000">
                  <c:v>0.88374277277701407</c:v>
                </c:pt>
                <c:pt idx="49">
                  <c:v>0.88374277277701407</c:v>
                </c:pt>
                <c:pt idx="50" formatCode="0.0000">
                  <c:v>0.87631636292174508</c:v>
                </c:pt>
                <c:pt idx="51">
                  <c:v>0.87631636292174508</c:v>
                </c:pt>
                <c:pt idx="52" formatCode="0.0000">
                  <c:v>0.8688899530664761</c:v>
                </c:pt>
                <c:pt idx="53" formatCode="0.0000">
                  <c:v>0.8688899530664761</c:v>
                </c:pt>
                <c:pt idx="54">
                  <c:v>0.8688899530664761</c:v>
                </c:pt>
                <c:pt idx="55" formatCode="0.0000">
                  <c:v>0.86139952243659268</c:v>
                </c:pt>
                <c:pt idx="56">
                  <c:v>0.86139952243659268</c:v>
                </c:pt>
                <c:pt idx="57" formatCode="0.0000">
                  <c:v>0.85390909180670926</c:v>
                </c:pt>
                <c:pt idx="58" formatCode="0.0000">
                  <c:v>0.85390909180670926</c:v>
                </c:pt>
                <c:pt idx="59">
                  <c:v>0.85390909180670926</c:v>
                </c:pt>
                <c:pt idx="60" formatCode="0.0000">
                  <c:v>0.84635237418010123</c:v>
                </c:pt>
                <c:pt idx="61" formatCode="0.0000">
                  <c:v>0.84635237418010123</c:v>
                </c:pt>
                <c:pt idx="62">
                  <c:v>0.84635237418010123</c:v>
                </c:pt>
                <c:pt idx="63" formatCode="0.0000">
                  <c:v>0.83872757801631648</c:v>
                </c:pt>
                <c:pt idx="64">
                  <c:v>0.83872757801631648</c:v>
                </c:pt>
                <c:pt idx="65" formatCode="0.0000">
                  <c:v>0.83110278185253184</c:v>
                </c:pt>
                <c:pt idx="66">
                  <c:v>0.83110278185253184</c:v>
                </c:pt>
                <c:pt idx="67" formatCode="0.0000">
                  <c:v>0.82347798568874719</c:v>
                </c:pt>
                <c:pt idx="68" formatCode="0.0000">
                  <c:v>0.82347798568874719</c:v>
                </c:pt>
                <c:pt idx="69" formatCode="0.0000">
                  <c:v>0.82347798568874719</c:v>
                </c:pt>
                <c:pt idx="70" formatCode="0.0000">
                  <c:v>0.82347798568874719</c:v>
                </c:pt>
                <c:pt idx="71">
                  <c:v>0.82347798568874719</c:v>
                </c:pt>
                <c:pt idx="72" formatCode="0.0000">
                  <c:v>0.81563533820599721</c:v>
                </c:pt>
                <c:pt idx="73">
                  <c:v>0.81563533820599721</c:v>
                </c:pt>
                <c:pt idx="74" formatCode="0.0000">
                  <c:v>0.80779269072324722</c:v>
                </c:pt>
                <c:pt idx="75">
                  <c:v>0.80779269072324722</c:v>
                </c:pt>
                <c:pt idx="76" formatCode="0.0000">
                  <c:v>0.79995004324049723</c:v>
                </c:pt>
                <c:pt idx="77">
                  <c:v>0.79995004324049723</c:v>
                </c:pt>
                <c:pt idx="78" formatCode="0.0000">
                  <c:v>0.79210739575774725</c:v>
                </c:pt>
                <c:pt idx="79">
                  <c:v>0.79210739575774725</c:v>
                </c:pt>
                <c:pt idx="80" formatCode="0.0000">
                  <c:v>0.78426474827499726</c:v>
                </c:pt>
                <c:pt idx="81">
                  <c:v>0.78426474827499726</c:v>
                </c:pt>
                <c:pt idx="82" formatCode="0.0000">
                  <c:v>0.77642210079224727</c:v>
                </c:pt>
                <c:pt idx="83">
                  <c:v>0.77642210079224727</c:v>
                </c:pt>
                <c:pt idx="84" formatCode="0.0000">
                  <c:v>0.76857945330949728</c:v>
                </c:pt>
                <c:pt idx="85">
                  <c:v>0.76857945330949728</c:v>
                </c:pt>
                <c:pt idx="86" formatCode="0.0000">
                  <c:v>0.7607368058267473</c:v>
                </c:pt>
                <c:pt idx="87">
                  <c:v>0.7607368058267473</c:v>
                </c:pt>
                <c:pt idx="88" formatCode="0.0000">
                  <c:v>0.75289415834399731</c:v>
                </c:pt>
                <c:pt idx="89">
                  <c:v>0.75289415834399731</c:v>
                </c:pt>
                <c:pt idx="90" formatCode="0.0000">
                  <c:v>0.74505151086124732</c:v>
                </c:pt>
                <c:pt idx="91">
                  <c:v>0.74505151086124732</c:v>
                </c:pt>
                <c:pt idx="92" formatCode="0.0000">
                  <c:v>0.73720886337849734</c:v>
                </c:pt>
                <c:pt idx="93">
                  <c:v>0.73720886337849734</c:v>
                </c:pt>
                <c:pt idx="94" formatCode="0.0000">
                  <c:v>0.72936621589574735</c:v>
                </c:pt>
                <c:pt idx="95">
                  <c:v>0.72936621589574735</c:v>
                </c:pt>
                <c:pt idx="96" formatCode="0.0000">
                  <c:v>0.72152356841299736</c:v>
                </c:pt>
                <c:pt idx="97">
                  <c:v>0.72152356841299736</c:v>
                </c:pt>
                <c:pt idx="98" formatCode="0.0000">
                  <c:v>0.71368092093024738</c:v>
                </c:pt>
                <c:pt idx="99">
                  <c:v>0.71368092093024738</c:v>
                </c:pt>
                <c:pt idx="100" formatCode="0.0000">
                  <c:v>0.70583827344749739</c:v>
                </c:pt>
                <c:pt idx="101" formatCode="0.0000">
                  <c:v>0.70583827344749739</c:v>
                </c:pt>
                <c:pt idx="102">
                  <c:v>0.70583827344749739</c:v>
                </c:pt>
                <c:pt idx="103" formatCode="0.0000">
                  <c:v>0.69790750633010978</c:v>
                </c:pt>
                <c:pt idx="104">
                  <c:v>0.69790750633010978</c:v>
                </c:pt>
                <c:pt idx="105" formatCode="0.0000">
                  <c:v>0.68997673921272218</c:v>
                </c:pt>
                <c:pt idx="106" formatCode="0.0000">
                  <c:v>0.68997673921272218</c:v>
                </c:pt>
                <c:pt idx="107">
                  <c:v>0.68997673921272218</c:v>
                </c:pt>
                <c:pt idx="108" formatCode="0.0000">
                  <c:v>0.68195375387303936</c:v>
                </c:pt>
                <c:pt idx="109">
                  <c:v>0.68195375387303936</c:v>
                </c:pt>
                <c:pt idx="110" formatCode="0.0000">
                  <c:v>0.67393076853335654</c:v>
                </c:pt>
                <c:pt idx="111">
                  <c:v>0.67393076853335654</c:v>
                </c:pt>
                <c:pt idx="112" formatCode="0.0000">
                  <c:v>0.66590778319367372</c:v>
                </c:pt>
                <c:pt idx="113">
                  <c:v>0.66590778319367372</c:v>
                </c:pt>
                <c:pt idx="114" formatCode="0.0000">
                  <c:v>0.6578847978539909</c:v>
                </c:pt>
                <c:pt idx="115">
                  <c:v>0.6578847978539909</c:v>
                </c:pt>
                <c:pt idx="116" formatCode="0.0000">
                  <c:v>0.64986181251430808</c:v>
                </c:pt>
                <c:pt idx="117">
                  <c:v>0.64986181251430808</c:v>
                </c:pt>
                <c:pt idx="118" formatCode="0.0000">
                  <c:v>0.64183882717462526</c:v>
                </c:pt>
                <c:pt idx="119" formatCode="0.0000">
                  <c:v>0.64183882717462526</c:v>
                </c:pt>
                <c:pt idx="120">
                  <c:v>0.64183882717462526</c:v>
                </c:pt>
                <c:pt idx="121" formatCode="0.0000">
                  <c:v>0.63371428505849081</c:v>
                </c:pt>
                <c:pt idx="122">
                  <c:v>0.63371428505849081</c:v>
                </c:pt>
                <c:pt idx="123" formatCode="0.0000">
                  <c:v>0.62558974294235636</c:v>
                </c:pt>
                <c:pt idx="124">
                  <c:v>0.62558974294235636</c:v>
                </c:pt>
                <c:pt idx="125" formatCode="0.0000">
                  <c:v>0.60934065871008736</c:v>
                </c:pt>
                <c:pt idx="126">
                  <c:v>0.60934065871008736</c:v>
                </c:pt>
                <c:pt idx="127" formatCode="0.0000">
                  <c:v>0.60121611659395291</c:v>
                </c:pt>
                <c:pt idx="128">
                  <c:v>0.60121611659395291</c:v>
                </c:pt>
                <c:pt idx="129" formatCode="0.0000">
                  <c:v>0.59309157447781846</c:v>
                </c:pt>
                <c:pt idx="130">
                  <c:v>0.59309157447781846</c:v>
                </c:pt>
                <c:pt idx="131" formatCode="0.0000">
                  <c:v>0.5849670323616839</c:v>
                </c:pt>
                <c:pt idx="132">
                  <c:v>0.5849670323616839</c:v>
                </c:pt>
                <c:pt idx="133" formatCode="0.0000">
                  <c:v>0.57684249024554946</c:v>
                </c:pt>
                <c:pt idx="134">
                  <c:v>0.57684249024554946</c:v>
                </c:pt>
                <c:pt idx="135" formatCode="0.0000">
                  <c:v>0.56871794812941501</c:v>
                </c:pt>
                <c:pt idx="136" formatCode="0.0000">
                  <c:v>0.56871794812941501</c:v>
                </c:pt>
                <c:pt idx="137">
                  <c:v>0.56871794812941501</c:v>
                </c:pt>
                <c:pt idx="138" formatCode="0.0000">
                  <c:v>0.5604756590260902</c:v>
                </c:pt>
                <c:pt idx="139" formatCode="0.0000">
                  <c:v>0.5604756590260902</c:v>
                </c:pt>
                <c:pt idx="140" formatCode="0.0000">
                  <c:v>0.5604756590260902</c:v>
                </c:pt>
                <c:pt idx="141">
                  <c:v>0.5604756590260902</c:v>
                </c:pt>
                <c:pt idx="142" formatCode="0.0000">
                  <c:v>0.55198360358630094</c:v>
                </c:pt>
                <c:pt idx="143" formatCode="0.0000">
                  <c:v>0.55198360358630094</c:v>
                </c:pt>
                <c:pt idx="144">
                  <c:v>0.55198360358630094</c:v>
                </c:pt>
                <c:pt idx="145" formatCode="0.0000">
                  <c:v>0.54335885978026499</c:v>
                </c:pt>
                <c:pt idx="146" formatCode="0.0000">
                  <c:v>0.54335885978026499</c:v>
                </c:pt>
                <c:pt idx="147">
                  <c:v>0.54335885978026499</c:v>
                </c:pt>
                <c:pt idx="148" formatCode="0.0000">
                  <c:v>0.534595007203164</c:v>
                </c:pt>
                <c:pt idx="149" formatCode="0.0000">
                  <c:v>0.534595007203164</c:v>
                </c:pt>
                <c:pt idx="150" formatCode="0.0000">
                  <c:v>0.534595007203164</c:v>
                </c:pt>
                <c:pt idx="151">
                  <c:v>0.534595007203164</c:v>
                </c:pt>
                <c:pt idx="152" formatCode="0.0000">
                  <c:v>0.52553407487768666</c:v>
                </c:pt>
                <c:pt idx="153">
                  <c:v>0.52553407487768666</c:v>
                </c:pt>
                <c:pt idx="154" formatCode="0.0000">
                  <c:v>0.51647314255220933</c:v>
                </c:pt>
                <c:pt idx="155">
                  <c:v>0.51647314255220933</c:v>
                </c:pt>
                <c:pt idx="156" formatCode="0.0000">
                  <c:v>0.507412210226732</c:v>
                </c:pt>
                <c:pt idx="157" formatCode="0.0000">
                  <c:v>0.507412210226732</c:v>
                </c:pt>
                <c:pt idx="158">
                  <c:v>0.507412210226732</c:v>
                </c:pt>
                <c:pt idx="159" formatCode="0.0000">
                  <c:v>0.49818653367715504</c:v>
                </c:pt>
                <c:pt idx="160" formatCode="0.0000">
                  <c:v>0.49818653367715504</c:v>
                </c:pt>
                <c:pt idx="161" formatCode="0.0000">
                  <c:v>0.49818653367715504</c:v>
                </c:pt>
                <c:pt idx="162">
                  <c:v>0.49818653367715504</c:v>
                </c:pt>
                <c:pt idx="163" formatCode="0.0000">
                  <c:v>0.48860602341413278</c:v>
                </c:pt>
                <c:pt idx="164">
                  <c:v>0.48860602341413278</c:v>
                </c:pt>
                <c:pt idx="165" formatCode="0.0000">
                  <c:v>0.47902551315111053</c:v>
                </c:pt>
                <c:pt idx="166">
                  <c:v>0.47902551315111053</c:v>
                </c:pt>
                <c:pt idx="167" formatCode="0.0000">
                  <c:v>0.46944500288808833</c:v>
                </c:pt>
                <c:pt idx="168" formatCode="0.0000">
                  <c:v>0.46944500288808833</c:v>
                </c:pt>
                <c:pt idx="169" formatCode="0.0000">
                  <c:v>0.46944500288808833</c:v>
                </c:pt>
                <c:pt idx="170">
                  <c:v>0.46944500288808833</c:v>
                </c:pt>
                <c:pt idx="171" formatCode="0.0000">
                  <c:v>0.45945681133727795</c:v>
                </c:pt>
                <c:pt idx="172">
                  <c:v>0.45945681133727795</c:v>
                </c:pt>
                <c:pt idx="173" formatCode="0.0000">
                  <c:v>0.44946861978646757</c:v>
                </c:pt>
                <c:pt idx="174">
                  <c:v>0.44946861978646757</c:v>
                </c:pt>
                <c:pt idx="175" formatCode="0.0000">
                  <c:v>0.43948042823565714</c:v>
                </c:pt>
                <c:pt idx="176">
                  <c:v>0.43948042823565714</c:v>
                </c:pt>
                <c:pt idx="177" formatCode="0.0000">
                  <c:v>0.42949223668484676</c:v>
                </c:pt>
                <c:pt idx="178" formatCode="0.0000">
                  <c:v>0.42949223668484676</c:v>
                </c:pt>
                <c:pt idx="179">
                  <c:v>0.42949223668484676</c:v>
                </c:pt>
                <c:pt idx="180" formatCode="0.0000">
                  <c:v>0.41926623104949323</c:v>
                </c:pt>
                <c:pt idx="181">
                  <c:v>0.41926623104949323</c:v>
                </c:pt>
                <c:pt idx="182" formatCode="0.0000">
                  <c:v>0.4090402254141397</c:v>
                </c:pt>
                <c:pt idx="183">
                  <c:v>0.4090402254141397</c:v>
                </c:pt>
                <c:pt idx="184" formatCode="0.0000">
                  <c:v>0.39881421977878623</c:v>
                </c:pt>
                <c:pt idx="185">
                  <c:v>0.39881421977878623</c:v>
                </c:pt>
                <c:pt idx="186" formatCode="0.0000">
                  <c:v>0.38858821414343275</c:v>
                </c:pt>
                <c:pt idx="187" formatCode="0.0000">
                  <c:v>0.38858821414343275</c:v>
                </c:pt>
                <c:pt idx="188" formatCode="0.0000">
                  <c:v>0.38858821414343275</c:v>
                </c:pt>
                <c:pt idx="189">
                  <c:v>0.38858821414343275</c:v>
                </c:pt>
                <c:pt idx="190" formatCode="0.0000">
                  <c:v>0.37779409708389294</c:v>
                </c:pt>
                <c:pt idx="191" formatCode="0.0000">
                  <c:v>0.37779409708389294</c:v>
                </c:pt>
                <c:pt idx="192">
                  <c:v>0.37779409708389294</c:v>
                </c:pt>
                <c:pt idx="193" formatCode="0.0000">
                  <c:v>0.36668250599319019</c:v>
                </c:pt>
                <c:pt idx="194" formatCode="0.0000">
                  <c:v>0.36668250599319019</c:v>
                </c:pt>
                <c:pt idx="195">
                  <c:v>0.36668250599319019</c:v>
                </c:pt>
                <c:pt idx="196" formatCode="0.0000">
                  <c:v>0.35522367768090302</c:v>
                </c:pt>
                <c:pt idx="197">
                  <c:v>0.35522367768090302</c:v>
                </c:pt>
                <c:pt idx="198" formatCode="0.0000">
                  <c:v>0.34376484936861584</c:v>
                </c:pt>
                <c:pt idx="199" formatCode="0.0000">
                  <c:v>0.34376484936861584</c:v>
                </c:pt>
                <c:pt idx="200">
                  <c:v>0.34376484936861584</c:v>
                </c:pt>
                <c:pt idx="201" formatCode="0.0000">
                  <c:v>0.33191088904556015</c:v>
                </c:pt>
                <c:pt idx="202" formatCode="0.0000">
                  <c:v>0.33191088904556015</c:v>
                </c:pt>
                <c:pt idx="203" formatCode="0.0000">
                  <c:v>0.33191088904556015</c:v>
                </c:pt>
                <c:pt idx="204">
                  <c:v>0.33191088904556015</c:v>
                </c:pt>
                <c:pt idx="205" formatCode="0.0000">
                  <c:v>0.31914508562073091</c:v>
                </c:pt>
                <c:pt idx="206">
                  <c:v>0.31914508562073091</c:v>
                </c:pt>
                <c:pt idx="207" formatCode="0.0000">
                  <c:v>0.30637928219590166</c:v>
                </c:pt>
                <c:pt idx="208">
                  <c:v>0.30637928219590166</c:v>
                </c:pt>
                <c:pt idx="209" formatCode="0.0000">
                  <c:v>0.29361347877107241</c:v>
                </c:pt>
                <c:pt idx="210" formatCode="0.0000">
                  <c:v>0.29361347877107241</c:v>
                </c:pt>
                <c:pt idx="211" formatCode="0.0000">
                  <c:v>0.29361347877107241</c:v>
                </c:pt>
                <c:pt idx="212">
                  <c:v>0.29361347877107241</c:v>
                </c:pt>
                <c:pt idx="213" formatCode="0.0000">
                  <c:v>0.2796318845438785</c:v>
                </c:pt>
                <c:pt idx="214" formatCode="0.0000">
                  <c:v>0.2796318845438785</c:v>
                </c:pt>
                <c:pt idx="215">
                  <c:v>0.2796318845438785</c:v>
                </c:pt>
                <c:pt idx="216" formatCode="0.0000">
                  <c:v>0.26491441693630591</c:v>
                </c:pt>
                <c:pt idx="217" formatCode="0.0000">
                  <c:v>0.26491441693630591</c:v>
                </c:pt>
                <c:pt idx="218" formatCode="0.0000">
                  <c:v>0.26491441693630591</c:v>
                </c:pt>
                <c:pt idx="219" formatCode="0.0000">
                  <c:v>0.26491441693630591</c:v>
                </c:pt>
                <c:pt idx="220" formatCode="0.0000">
                  <c:v>0.26491441693630591</c:v>
                </c:pt>
                <c:pt idx="221">
                  <c:v>0.26491441693630591</c:v>
                </c:pt>
                <c:pt idx="222" formatCode="0.0000">
                  <c:v>0.24599195858371264</c:v>
                </c:pt>
                <c:pt idx="223" formatCode="0.0000">
                  <c:v>0.24599195858371264</c:v>
                </c:pt>
                <c:pt idx="224" formatCode="0.0000">
                  <c:v>0.24599195858371264</c:v>
                </c:pt>
                <c:pt idx="225">
                  <c:v>0.24599195858371264</c:v>
                </c:pt>
                <c:pt idx="226" formatCode="0.0000">
                  <c:v>0.22362905325792057</c:v>
                </c:pt>
                <c:pt idx="227" formatCode="0.0000">
                  <c:v>0.22362905325792057</c:v>
                </c:pt>
                <c:pt idx="228">
                  <c:v>0.22362905325792057</c:v>
                </c:pt>
                <c:pt idx="229" formatCode="0.0000">
                  <c:v>0.19878138067370715</c:v>
                </c:pt>
                <c:pt idx="230" formatCode="0.0000">
                  <c:v>0.19878138067370715</c:v>
                </c:pt>
                <c:pt idx="231">
                  <c:v>0.19878138067370715</c:v>
                </c:pt>
                <c:pt idx="232" formatCode="0.0000">
                  <c:v>0.17038404057746326</c:v>
                </c:pt>
                <c:pt idx="233" formatCode="0.0000">
                  <c:v>0.17038404057746326</c:v>
                </c:pt>
                <c:pt idx="234" formatCode="0.0000">
                  <c:v>0.17038404057746326</c:v>
                </c:pt>
                <c:pt idx="235" formatCode="0.0000">
                  <c:v>0.17038404057746326</c:v>
                </c:pt>
                <c:pt idx="236" formatCode="0.0000">
                  <c:v>0.17038404057746326</c:v>
                </c:pt>
                <c:pt idx="237" formatCode="0.0000">
                  <c:v>0.17038404057746326</c:v>
                </c:pt>
                <c:pt idx="238" formatCode="0.0000">
                  <c:v>0.1703840405774632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970-4FD4-9EA3-8E64117A66C2}"/>
            </c:ext>
          </c:extLst>
        </c:ser>
        <c:ser>
          <c:idx val="1"/>
          <c:order val="1"/>
          <c:tx>
            <c:strRef>
              <c:f>Sheet4!$E$428</c:f>
              <c:strCache>
                <c:ptCount val="1"/>
                <c:pt idx="0">
                  <c:v>MELD score ≧7</c:v>
                </c:pt>
              </c:strCache>
            </c:strRef>
          </c:tx>
          <c:spPr>
            <a:ln w="28575">
              <a:solidFill>
                <a:schemeClr val="tx1"/>
              </a:solidFill>
              <a:prstDash val="sysDot"/>
            </a:ln>
          </c:spPr>
          <c:marker>
            <c:symbol val="none"/>
          </c:marker>
          <c:xVal>
            <c:numRef>
              <c:f>Sheet4!$D$429:$D$783</c:f>
              <c:numCache>
                <c:formatCode>General</c:formatCode>
                <c:ptCount val="355"/>
                <c:pt idx="0">
                  <c:v>0</c:v>
                </c:pt>
                <c:pt idx="1">
                  <c:v>0</c:v>
                </c:pt>
                <c:pt idx="2">
                  <c:v>6</c:v>
                </c:pt>
                <c:pt idx="3">
                  <c:v>10</c:v>
                </c:pt>
                <c:pt idx="4">
                  <c:v>10</c:v>
                </c:pt>
                <c:pt idx="5">
                  <c:v>12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4</c:v>
                </c:pt>
                <c:pt idx="10">
                  <c:v>15</c:v>
                </c:pt>
                <c:pt idx="11">
                  <c:v>23</c:v>
                </c:pt>
                <c:pt idx="12">
                  <c:v>23</c:v>
                </c:pt>
                <c:pt idx="13">
                  <c:v>31</c:v>
                </c:pt>
                <c:pt idx="14">
                  <c:v>32</c:v>
                </c:pt>
                <c:pt idx="15">
                  <c:v>32</c:v>
                </c:pt>
                <c:pt idx="16">
                  <c:v>34</c:v>
                </c:pt>
                <c:pt idx="17">
                  <c:v>34</c:v>
                </c:pt>
                <c:pt idx="18">
                  <c:v>37</c:v>
                </c:pt>
                <c:pt idx="19">
                  <c:v>37</c:v>
                </c:pt>
                <c:pt idx="20">
                  <c:v>42</c:v>
                </c:pt>
                <c:pt idx="21">
                  <c:v>49</c:v>
                </c:pt>
                <c:pt idx="22">
                  <c:v>50</c:v>
                </c:pt>
                <c:pt idx="23">
                  <c:v>50</c:v>
                </c:pt>
                <c:pt idx="24">
                  <c:v>51</c:v>
                </c:pt>
                <c:pt idx="25">
                  <c:v>51</c:v>
                </c:pt>
                <c:pt idx="26">
                  <c:v>56</c:v>
                </c:pt>
                <c:pt idx="27">
                  <c:v>60</c:v>
                </c:pt>
                <c:pt idx="28">
                  <c:v>60</c:v>
                </c:pt>
                <c:pt idx="29">
                  <c:v>63</c:v>
                </c:pt>
                <c:pt idx="30">
                  <c:v>68</c:v>
                </c:pt>
                <c:pt idx="31">
                  <c:v>68</c:v>
                </c:pt>
                <c:pt idx="32">
                  <c:v>70</c:v>
                </c:pt>
                <c:pt idx="33">
                  <c:v>71</c:v>
                </c:pt>
                <c:pt idx="34">
                  <c:v>74</c:v>
                </c:pt>
                <c:pt idx="35">
                  <c:v>74</c:v>
                </c:pt>
                <c:pt idx="36">
                  <c:v>106</c:v>
                </c:pt>
                <c:pt idx="37">
                  <c:v>106</c:v>
                </c:pt>
                <c:pt idx="38">
                  <c:v>128</c:v>
                </c:pt>
                <c:pt idx="39">
                  <c:v>130</c:v>
                </c:pt>
                <c:pt idx="40">
                  <c:v>130</c:v>
                </c:pt>
                <c:pt idx="41">
                  <c:v>131</c:v>
                </c:pt>
                <c:pt idx="42">
                  <c:v>131</c:v>
                </c:pt>
                <c:pt idx="43">
                  <c:v>133</c:v>
                </c:pt>
                <c:pt idx="44">
                  <c:v>133</c:v>
                </c:pt>
                <c:pt idx="45">
                  <c:v>161</c:v>
                </c:pt>
                <c:pt idx="46">
                  <c:v>172</c:v>
                </c:pt>
                <c:pt idx="47">
                  <c:v>188</c:v>
                </c:pt>
                <c:pt idx="48">
                  <c:v>195</c:v>
                </c:pt>
                <c:pt idx="49">
                  <c:v>195</c:v>
                </c:pt>
                <c:pt idx="50">
                  <c:v>196</c:v>
                </c:pt>
                <c:pt idx="51">
                  <c:v>196</c:v>
                </c:pt>
                <c:pt idx="52">
                  <c:v>199</c:v>
                </c:pt>
                <c:pt idx="53">
                  <c:v>199</c:v>
                </c:pt>
                <c:pt idx="54">
                  <c:v>205</c:v>
                </c:pt>
                <c:pt idx="55">
                  <c:v>236</c:v>
                </c:pt>
                <c:pt idx="56">
                  <c:v>236</c:v>
                </c:pt>
                <c:pt idx="57">
                  <c:v>245</c:v>
                </c:pt>
                <c:pt idx="58">
                  <c:v>245</c:v>
                </c:pt>
                <c:pt idx="59">
                  <c:v>246</c:v>
                </c:pt>
                <c:pt idx="60">
                  <c:v>265</c:v>
                </c:pt>
                <c:pt idx="61">
                  <c:v>265</c:v>
                </c:pt>
                <c:pt idx="62">
                  <c:v>266</c:v>
                </c:pt>
                <c:pt idx="63">
                  <c:v>278</c:v>
                </c:pt>
                <c:pt idx="64">
                  <c:v>278</c:v>
                </c:pt>
                <c:pt idx="65">
                  <c:v>286</c:v>
                </c:pt>
                <c:pt idx="66">
                  <c:v>287</c:v>
                </c:pt>
                <c:pt idx="67">
                  <c:v>294</c:v>
                </c:pt>
                <c:pt idx="68">
                  <c:v>308</c:v>
                </c:pt>
                <c:pt idx="69">
                  <c:v>319</c:v>
                </c:pt>
                <c:pt idx="70">
                  <c:v>335</c:v>
                </c:pt>
                <c:pt idx="71">
                  <c:v>336</c:v>
                </c:pt>
                <c:pt idx="72">
                  <c:v>336</c:v>
                </c:pt>
                <c:pt idx="73">
                  <c:v>350</c:v>
                </c:pt>
                <c:pt idx="74">
                  <c:v>360</c:v>
                </c:pt>
                <c:pt idx="75">
                  <c:v>360</c:v>
                </c:pt>
                <c:pt idx="76">
                  <c:v>362</c:v>
                </c:pt>
                <c:pt idx="77">
                  <c:v>362</c:v>
                </c:pt>
                <c:pt idx="78">
                  <c:v>372</c:v>
                </c:pt>
                <c:pt idx="79">
                  <c:v>396</c:v>
                </c:pt>
                <c:pt idx="80">
                  <c:v>399</c:v>
                </c:pt>
                <c:pt idx="81">
                  <c:v>399</c:v>
                </c:pt>
                <c:pt idx="82">
                  <c:v>409</c:v>
                </c:pt>
                <c:pt idx="83">
                  <c:v>409</c:v>
                </c:pt>
                <c:pt idx="84">
                  <c:v>412</c:v>
                </c:pt>
                <c:pt idx="85">
                  <c:v>416</c:v>
                </c:pt>
                <c:pt idx="86">
                  <c:v>433</c:v>
                </c:pt>
                <c:pt idx="87">
                  <c:v>433</c:v>
                </c:pt>
                <c:pt idx="88">
                  <c:v>435</c:v>
                </c:pt>
                <c:pt idx="89">
                  <c:v>440</c:v>
                </c:pt>
                <c:pt idx="90">
                  <c:v>440</c:v>
                </c:pt>
                <c:pt idx="91">
                  <c:v>448</c:v>
                </c:pt>
                <c:pt idx="92">
                  <c:v>450</c:v>
                </c:pt>
                <c:pt idx="93">
                  <c:v>450</c:v>
                </c:pt>
                <c:pt idx="94">
                  <c:v>456</c:v>
                </c:pt>
                <c:pt idx="95">
                  <c:v>456</c:v>
                </c:pt>
                <c:pt idx="96">
                  <c:v>464</c:v>
                </c:pt>
                <c:pt idx="97">
                  <c:v>464</c:v>
                </c:pt>
                <c:pt idx="98">
                  <c:v>477</c:v>
                </c:pt>
                <c:pt idx="99">
                  <c:v>477</c:v>
                </c:pt>
                <c:pt idx="100">
                  <c:v>483</c:v>
                </c:pt>
                <c:pt idx="101">
                  <c:v>504</c:v>
                </c:pt>
                <c:pt idx="102">
                  <c:v>504</c:v>
                </c:pt>
                <c:pt idx="103">
                  <c:v>529</c:v>
                </c:pt>
                <c:pt idx="104">
                  <c:v>529</c:v>
                </c:pt>
                <c:pt idx="105">
                  <c:v>543</c:v>
                </c:pt>
                <c:pt idx="106">
                  <c:v>543</c:v>
                </c:pt>
                <c:pt idx="107">
                  <c:v>549</c:v>
                </c:pt>
                <c:pt idx="108">
                  <c:v>549</c:v>
                </c:pt>
                <c:pt idx="109">
                  <c:v>566</c:v>
                </c:pt>
                <c:pt idx="110">
                  <c:v>566</c:v>
                </c:pt>
                <c:pt idx="111">
                  <c:v>569</c:v>
                </c:pt>
                <c:pt idx="112">
                  <c:v>569</c:v>
                </c:pt>
                <c:pt idx="113">
                  <c:v>573</c:v>
                </c:pt>
                <c:pt idx="114">
                  <c:v>573</c:v>
                </c:pt>
                <c:pt idx="115">
                  <c:v>578</c:v>
                </c:pt>
                <c:pt idx="116">
                  <c:v>583</c:v>
                </c:pt>
                <c:pt idx="117">
                  <c:v>595</c:v>
                </c:pt>
                <c:pt idx="118">
                  <c:v>595</c:v>
                </c:pt>
                <c:pt idx="119">
                  <c:v>625</c:v>
                </c:pt>
                <c:pt idx="120">
                  <c:v>625</c:v>
                </c:pt>
                <c:pt idx="121">
                  <c:v>628</c:v>
                </c:pt>
                <c:pt idx="122">
                  <c:v>669</c:v>
                </c:pt>
                <c:pt idx="123">
                  <c:v>669</c:v>
                </c:pt>
                <c:pt idx="124">
                  <c:v>677</c:v>
                </c:pt>
                <c:pt idx="125">
                  <c:v>677</c:v>
                </c:pt>
                <c:pt idx="126">
                  <c:v>701</c:v>
                </c:pt>
                <c:pt idx="127">
                  <c:v>701</c:v>
                </c:pt>
                <c:pt idx="128">
                  <c:v>707</c:v>
                </c:pt>
                <c:pt idx="129">
                  <c:v>707</c:v>
                </c:pt>
                <c:pt idx="130">
                  <c:v>709</c:v>
                </c:pt>
                <c:pt idx="131">
                  <c:v>709</c:v>
                </c:pt>
                <c:pt idx="132">
                  <c:v>714</c:v>
                </c:pt>
                <c:pt idx="133">
                  <c:v>714</c:v>
                </c:pt>
                <c:pt idx="134">
                  <c:v>718</c:v>
                </c:pt>
                <c:pt idx="135">
                  <c:v>733</c:v>
                </c:pt>
                <c:pt idx="136">
                  <c:v>733</c:v>
                </c:pt>
                <c:pt idx="137">
                  <c:v>738</c:v>
                </c:pt>
                <c:pt idx="138">
                  <c:v>746</c:v>
                </c:pt>
                <c:pt idx="139">
                  <c:v>746</c:v>
                </c:pt>
                <c:pt idx="140">
                  <c:v>765</c:v>
                </c:pt>
                <c:pt idx="141">
                  <c:v>768</c:v>
                </c:pt>
                <c:pt idx="142">
                  <c:v>782</c:v>
                </c:pt>
                <c:pt idx="143">
                  <c:v>791</c:v>
                </c:pt>
                <c:pt idx="144">
                  <c:v>791.70269490740611</c:v>
                </c:pt>
                <c:pt idx="145">
                  <c:v>796</c:v>
                </c:pt>
                <c:pt idx="146">
                  <c:v>796</c:v>
                </c:pt>
                <c:pt idx="147">
                  <c:v>797</c:v>
                </c:pt>
                <c:pt idx="148">
                  <c:v>801</c:v>
                </c:pt>
                <c:pt idx="149">
                  <c:v>801</c:v>
                </c:pt>
                <c:pt idx="150">
                  <c:v>806</c:v>
                </c:pt>
                <c:pt idx="151">
                  <c:v>806</c:v>
                </c:pt>
                <c:pt idx="152">
                  <c:v>811</c:v>
                </c:pt>
                <c:pt idx="153">
                  <c:v>811</c:v>
                </c:pt>
                <c:pt idx="154">
                  <c:v>817</c:v>
                </c:pt>
                <c:pt idx="155">
                  <c:v>817</c:v>
                </c:pt>
                <c:pt idx="156">
                  <c:v>818</c:v>
                </c:pt>
                <c:pt idx="157">
                  <c:v>818</c:v>
                </c:pt>
                <c:pt idx="158">
                  <c:v>833</c:v>
                </c:pt>
                <c:pt idx="159">
                  <c:v>833</c:v>
                </c:pt>
                <c:pt idx="160">
                  <c:v>835</c:v>
                </c:pt>
                <c:pt idx="161">
                  <c:v>835</c:v>
                </c:pt>
                <c:pt idx="162">
                  <c:v>836</c:v>
                </c:pt>
                <c:pt idx="163">
                  <c:v>836</c:v>
                </c:pt>
                <c:pt idx="164">
                  <c:v>859</c:v>
                </c:pt>
                <c:pt idx="165">
                  <c:v>859</c:v>
                </c:pt>
                <c:pt idx="166">
                  <c:v>882</c:v>
                </c:pt>
                <c:pt idx="167">
                  <c:v>882</c:v>
                </c:pt>
                <c:pt idx="168">
                  <c:v>957</c:v>
                </c:pt>
                <c:pt idx="169">
                  <c:v>957</c:v>
                </c:pt>
                <c:pt idx="170">
                  <c:v>972</c:v>
                </c:pt>
                <c:pt idx="171">
                  <c:v>974</c:v>
                </c:pt>
                <c:pt idx="172">
                  <c:v>995</c:v>
                </c:pt>
                <c:pt idx="173">
                  <c:v>995</c:v>
                </c:pt>
                <c:pt idx="174">
                  <c:v>1006</c:v>
                </c:pt>
                <c:pt idx="175">
                  <c:v>1006</c:v>
                </c:pt>
                <c:pt idx="176">
                  <c:v>1007</c:v>
                </c:pt>
                <c:pt idx="177">
                  <c:v>1007</c:v>
                </c:pt>
                <c:pt idx="178">
                  <c:v>1008</c:v>
                </c:pt>
                <c:pt idx="179">
                  <c:v>1016</c:v>
                </c:pt>
                <c:pt idx="180">
                  <c:v>1016</c:v>
                </c:pt>
                <c:pt idx="181">
                  <c:v>1023</c:v>
                </c:pt>
                <c:pt idx="182">
                  <c:v>1023</c:v>
                </c:pt>
                <c:pt idx="183">
                  <c:v>1026</c:v>
                </c:pt>
                <c:pt idx="184">
                  <c:v>1026</c:v>
                </c:pt>
                <c:pt idx="185">
                  <c:v>1045</c:v>
                </c:pt>
                <c:pt idx="186">
                  <c:v>1045</c:v>
                </c:pt>
                <c:pt idx="187">
                  <c:v>1052</c:v>
                </c:pt>
                <c:pt idx="188">
                  <c:v>1065</c:v>
                </c:pt>
                <c:pt idx="189">
                  <c:v>1065</c:v>
                </c:pt>
                <c:pt idx="190">
                  <c:v>1069</c:v>
                </c:pt>
                <c:pt idx="191">
                  <c:v>1069</c:v>
                </c:pt>
                <c:pt idx="192">
                  <c:v>1083</c:v>
                </c:pt>
                <c:pt idx="193">
                  <c:v>1099</c:v>
                </c:pt>
                <c:pt idx="194">
                  <c:v>1101</c:v>
                </c:pt>
                <c:pt idx="195">
                  <c:v>1101</c:v>
                </c:pt>
                <c:pt idx="196">
                  <c:v>1105</c:v>
                </c:pt>
                <c:pt idx="197">
                  <c:v>1116</c:v>
                </c:pt>
                <c:pt idx="198">
                  <c:v>1116</c:v>
                </c:pt>
                <c:pt idx="199">
                  <c:v>1127</c:v>
                </c:pt>
                <c:pt idx="200">
                  <c:v>1127</c:v>
                </c:pt>
                <c:pt idx="201">
                  <c:v>1128</c:v>
                </c:pt>
                <c:pt idx="202">
                  <c:v>1128</c:v>
                </c:pt>
                <c:pt idx="203">
                  <c:v>1138</c:v>
                </c:pt>
                <c:pt idx="204">
                  <c:v>1138</c:v>
                </c:pt>
                <c:pt idx="205">
                  <c:v>1139</c:v>
                </c:pt>
                <c:pt idx="206">
                  <c:v>1139</c:v>
                </c:pt>
                <c:pt idx="207">
                  <c:v>1144</c:v>
                </c:pt>
                <c:pt idx="208">
                  <c:v>1144</c:v>
                </c:pt>
                <c:pt idx="209">
                  <c:v>1148</c:v>
                </c:pt>
                <c:pt idx="210">
                  <c:v>1148</c:v>
                </c:pt>
                <c:pt idx="211">
                  <c:v>1201</c:v>
                </c:pt>
                <c:pt idx="212">
                  <c:v>1201</c:v>
                </c:pt>
                <c:pt idx="213">
                  <c:v>1206</c:v>
                </c:pt>
                <c:pt idx="214">
                  <c:v>1206</c:v>
                </c:pt>
                <c:pt idx="215">
                  <c:v>1209</c:v>
                </c:pt>
                <c:pt idx="216">
                  <c:v>1209</c:v>
                </c:pt>
                <c:pt idx="217">
                  <c:v>1247</c:v>
                </c:pt>
                <c:pt idx="218">
                  <c:v>1263</c:v>
                </c:pt>
                <c:pt idx="219">
                  <c:v>1263</c:v>
                </c:pt>
                <c:pt idx="220">
                  <c:v>1269</c:v>
                </c:pt>
                <c:pt idx="221">
                  <c:v>1280</c:v>
                </c:pt>
                <c:pt idx="222">
                  <c:v>1280</c:v>
                </c:pt>
                <c:pt idx="223">
                  <c:v>1286</c:v>
                </c:pt>
                <c:pt idx="224">
                  <c:v>1286</c:v>
                </c:pt>
                <c:pt idx="225">
                  <c:v>1318</c:v>
                </c:pt>
                <c:pt idx="226">
                  <c:v>1318</c:v>
                </c:pt>
                <c:pt idx="227">
                  <c:v>1324</c:v>
                </c:pt>
                <c:pt idx="228">
                  <c:v>1360</c:v>
                </c:pt>
                <c:pt idx="229">
                  <c:v>1360</c:v>
                </c:pt>
                <c:pt idx="230">
                  <c:v>1394.7026949074061</c:v>
                </c:pt>
                <c:pt idx="231">
                  <c:v>1406</c:v>
                </c:pt>
                <c:pt idx="232">
                  <c:v>1415</c:v>
                </c:pt>
                <c:pt idx="233">
                  <c:v>1415</c:v>
                </c:pt>
                <c:pt idx="234">
                  <c:v>1416</c:v>
                </c:pt>
                <c:pt idx="235">
                  <c:v>1416</c:v>
                </c:pt>
                <c:pt idx="236">
                  <c:v>1441</c:v>
                </c:pt>
                <c:pt idx="237">
                  <c:v>1441</c:v>
                </c:pt>
                <c:pt idx="238">
                  <c:v>1454</c:v>
                </c:pt>
                <c:pt idx="239">
                  <c:v>1454</c:v>
                </c:pt>
                <c:pt idx="240">
                  <c:v>1498</c:v>
                </c:pt>
                <c:pt idx="241">
                  <c:v>1577</c:v>
                </c:pt>
                <c:pt idx="242">
                  <c:v>1577</c:v>
                </c:pt>
                <c:pt idx="243">
                  <c:v>1578</c:v>
                </c:pt>
                <c:pt idx="244">
                  <c:v>1578</c:v>
                </c:pt>
                <c:pt idx="245">
                  <c:v>1581</c:v>
                </c:pt>
                <c:pt idx="246">
                  <c:v>1581</c:v>
                </c:pt>
                <c:pt idx="247">
                  <c:v>1593</c:v>
                </c:pt>
                <c:pt idx="248">
                  <c:v>1593</c:v>
                </c:pt>
                <c:pt idx="249">
                  <c:v>1665</c:v>
                </c:pt>
                <c:pt idx="250">
                  <c:v>1665</c:v>
                </c:pt>
                <c:pt idx="251">
                  <c:v>1674</c:v>
                </c:pt>
                <c:pt idx="252">
                  <c:v>1674</c:v>
                </c:pt>
                <c:pt idx="253">
                  <c:v>1697</c:v>
                </c:pt>
                <c:pt idx="254">
                  <c:v>1697</c:v>
                </c:pt>
                <c:pt idx="255">
                  <c:v>1706</c:v>
                </c:pt>
                <c:pt idx="256">
                  <c:v>1706</c:v>
                </c:pt>
                <c:pt idx="257">
                  <c:v>1709</c:v>
                </c:pt>
                <c:pt idx="258">
                  <c:v>1709</c:v>
                </c:pt>
                <c:pt idx="259">
                  <c:v>1721</c:v>
                </c:pt>
                <c:pt idx="260">
                  <c:v>1721</c:v>
                </c:pt>
                <c:pt idx="261">
                  <c:v>1722.7026949074061</c:v>
                </c:pt>
                <c:pt idx="262">
                  <c:v>1766</c:v>
                </c:pt>
                <c:pt idx="263">
                  <c:v>1766</c:v>
                </c:pt>
                <c:pt idx="264">
                  <c:v>1767</c:v>
                </c:pt>
                <c:pt idx="265">
                  <c:v>1767</c:v>
                </c:pt>
                <c:pt idx="266">
                  <c:v>1789.7026949074061</c:v>
                </c:pt>
                <c:pt idx="267">
                  <c:v>1834</c:v>
                </c:pt>
                <c:pt idx="268">
                  <c:v>1834</c:v>
                </c:pt>
                <c:pt idx="269">
                  <c:v>1836</c:v>
                </c:pt>
                <c:pt idx="270">
                  <c:v>1836</c:v>
                </c:pt>
                <c:pt idx="271">
                  <c:v>1854</c:v>
                </c:pt>
                <c:pt idx="272">
                  <c:v>1854</c:v>
                </c:pt>
                <c:pt idx="273">
                  <c:v>1867</c:v>
                </c:pt>
                <c:pt idx="274">
                  <c:v>1867</c:v>
                </c:pt>
                <c:pt idx="275">
                  <c:v>1903</c:v>
                </c:pt>
                <c:pt idx="276">
                  <c:v>1903</c:v>
                </c:pt>
                <c:pt idx="277">
                  <c:v>1922.7026949074061</c:v>
                </c:pt>
                <c:pt idx="278">
                  <c:v>1938.7026949074061</c:v>
                </c:pt>
                <c:pt idx="279">
                  <c:v>1960</c:v>
                </c:pt>
                <c:pt idx="280">
                  <c:v>1960</c:v>
                </c:pt>
                <c:pt idx="281">
                  <c:v>2022</c:v>
                </c:pt>
                <c:pt idx="282">
                  <c:v>2022</c:v>
                </c:pt>
                <c:pt idx="283">
                  <c:v>2035</c:v>
                </c:pt>
                <c:pt idx="284">
                  <c:v>2085</c:v>
                </c:pt>
                <c:pt idx="285">
                  <c:v>2085</c:v>
                </c:pt>
                <c:pt idx="286">
                  <c:v>2187</c:v>
                </c:pt>
                <c:pt idx="287">
                  <c:v>2187</c:v>
                </c:pt>
                <c:pt idx="288">
                  <c:v>2225</c:v>
                </c:pt>
                <c:pt idx="289">
                  <c:v>2225.7026949074061</c:v>
                </c:pt>
                <c:pt idx="290">
                  <c:v>2227</c:v>
                </c:pt>
                <c:pt idx="291">
                  <c:v>2232.7026949074061</c:v>
                </c:pt>
                <c:pt idx="292">
                  <c:v>2239</c:v>
                </c:pt>
                <c:pt idx="293">
                  <c:v>2239</c:v>
                </c:pt>
                <c:pt idx="294">
                  <c:v>2247</c:v>
                </c:pt>
                <c:pt idx="295">
                  <c:v>2247</c:v>
                </c:pt>
                <c:pt idx="296">
                  <c:v>2262.7026949074061</c:v>
                </c:pt>
                <c:pt idx="297">
                  <c:v>2324</c:v>
                </c:pt>
                <c:pt idx="298">
                  <c:v>2324</c:v>
                </c:pt>
                <c:pt idx="299">
                  <c:v>2353</c:v>
                </c:pt>
                <c:pt idx="300">
                  <c:v>2353</c:v>
                </c:pt>
                <c:pt idx="301">
                  <c:v>2378</c:v>
                </c:pt>
                <c:pt idx="302">
                  <c:v>2393.7026949074061</c:v>
                </c:pt>
                <c:pt idx="303">
                  <c:v>2410</c:v>
                </c:pt>
                <c:pt idx="304">
                  <c:v>2445</c:v>
                </c:pt>
                <c:pt idx="305">
                  <c:v>2445</c:v>
                </c:pt>
                <c:pt idx="306">
                  <c:v>2475</c:v>
                </c:pt>
                <c:pt idx="307">
                  <c:v>2475</c:v>
                </c:pt>
                <c:pt idx="308">
                  <c:v>2487</c:v>
                </c:pt>
                <c:pt idx="309">
                  <c:v>2487</c:v>
                </c:pt>
                <c:pt idx="310">
                  <c:v>2513.7026949074061</c:v>
                </c:pt>
                <c:pt idx="311">
                  <c:v>2555</c:v>
                </c:pt>
                <c:pt idx="312">
                  <c:v>2555</c:v>
                </c:pt>
                <c:pt idx="313">
                  <c:v>2596</c:v>
                </c:pt>
                <c:pt idx="314">
                  <c:v>2596</c:v>
                </c:pt>
                <c:pt idx="315">
                  <c:v>2648</c:v>
                </c:pt>
                <c:pt idx="316">
                  <c:v>2648</c:v>
                </c:pt>
                <c:pt idx="317">
                  <c:v>2657</c:v>
                </c:pt>
                <c:pt idx="318">
                  <c:v>2657</c:v>
                </c:pt>
                <c:pt idx="319">
                  <c:v>2709.7026949074061</c:v>
                </c:pt>
                <c:pt idx="320">
                  <c:v>2755</c:v>
                </c:pt>
                <c:pt idx="321">
                  <c:v>2755</c:v>
                </c:pt>
                <c:pt idx="322">
                  <c:v>2796</c:v>
                </c:pt>
                <c:pt idx="323">
                  <c:v>2824</c:v>
                </c:pt>
                <c:pt idx="324">
                  <c:v>2849</c:v>
                </c:pt>
                <c:pt idx="325">
                  <c:v>2849</c:v>
                </c:pt>
                <c:pt idx="326">
                  <c:v>2851</c:v>
                </c:pt>
                <c:pt idx="327">
                  <c:v>2851</c:v>
                </c:pt>
                <c:pt idx="328">
                  <c:v>2895</c:v>
                </c:pt>
                <c:pt idx="329">
                  <c:v>2895</c:v>
                </c:pt>
                <c:pt idx="330">
                  <c:v>2967.7026949074061</c:v>
                </c:pt>
                <c:pt idx="331">
                  <c:v>2999</c:v>
                </c:pt>
                <c:pt idx="332">
                  <c:v>2999</c:v>
                </c:pt>
                <c:pt idx="333">
                  <c:v>3017.7026949074061</c:v>
                </c:pt>
                <c:pt idx="334">
                  <c:v>3055</c:v>
                </c:pt>
                <c:pt idx="335">
                  <c:v>3055</c:v>
                </c:pt>
                <c:pt idx="336">
                  <c:v>3076</c:v>
                </c:pt>
                <c:pt idx="337">
                  <c:v>3076</c:v>
                </c:pt>
                <c:pt idx="338">
                  <c:v>3107.7026949074061</c:v>
                </c:pt>
                <c:pt idx="339">
                  <c:v>3181</c:v>
                </c:pt>
                <c:pt idx="340">
                  <c:v>3181</c:v>
                </c:pt>
                <c:pt idx="341">
                  <c:v>3437.7026949074061</c:v>
                </c:pt>
                <c:pt idx="342">
                  <c:v>3668</c:v>
                </c:pt>
                <c:pt idx="343">
                  <c:v>3668</c:v>
                </c:pt>
                <c:pt idx="344">
                  <c:v>3892.7026949074061</c:v>
                </c:pt>
                <c:pt idx="345">
                  <c:v>3991</c:v>
                </c:pt>
                <c:pt idx="346">
                  <c:v>3991</c:v>
                </c:pt>
                <c:pt idx="347">
                  <c:v>4050</c:v>
                </c:pt>
                <c:pt idx="348">
                  <c:v>4141.7026949074061</c:v>
                </c:pt>
                <c:pt idx="349">
                  <c:v>4175</c:v>
                </c:pt>
                <c:pt idx="350">
                  <c:v>4175</c:v>
                </c:pt>
                <c:pt idx="351">
                  <c:v>4213.7026949074061</c:v>
                </c:pt>
                <c:pt idx="352">
                  <c:v>4750</c:v>
                </c:pt>
                <c:pt idx="353">
                  <c:v>4750</c:v>
                </c:pt>
                <c:pt idx="354">
                  <c:v>5061.7026949074061</c:v>
                </c:pt>
              </c:numCache>
            </c:numRef>
          </c:xVal>
          <c:yVal>
            <c:numRef>
              <c:f>Sheet4!$E$429:$E$783</c:f>
              <c:numCache>
                <c:formatCode>0.0000</c:formatCode>
                <c:ptCount val="35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 formatCode="General">
                  <c:v>1</c:v>
                </c:pt>
                <c:pt idx="4">
                  <c:v>0.99549549549549554</c:v>
                </c:pt>
                <c:pt idx="5" formatCode="General">
                  <c:v>0.99549549549549554</c:v>
                </c:pt>
                <c:pt idx="6">
                  <c:v>0.99099099099099108</c:v>
                </c:pt>
                <c:pt idx="7">
                  <c:v>0.99099099099099108</c:v>
                </c:pt>
                <c:pt idx="8" formatCode="General">
                  <c:v>0.99099099099099108</c:v>
                </c:pt>
                <c:pt idx="9">
                  <c:v>0.98644516075708744</c:v>
                </c:pt>
                <c:pt idx="10">
                  <c:v>0.98644516075708744</c:v>
                </c:pt>
                <c:pt idx="11" formatCode="General">
                  <c:v>0.98644516075708744</c:v>
                </c:pt>
                <c:pt idx="12">
                  <c:v>0.98187828501284169</c:v>
                </c:pt>
                <c:pt idx="13">
                  <c:v>0.98187828501284169</c:v>
                </c:pt>
                <c:pt idx="14" formatCode="General">
                  <c:v>0.98187828501284169</c:v>
                </c:pt>
                <c:pt idx="15">
                  <c:v>0.97729006872773505</c:v>
                </c:pt>
                <c:pt idx="16" formatCode="General">
                  <c:v>0.97729006872773505</c:v>
                </c:pt>
                <c:pt idx="17">
                  <c:v>0.9727018524426283</c:v>
                </c:pt>
                <c:pt idx="18" formatCode="General">
                  <c:v>0.9727018524426283</c:v>
                </c:pt>
                <c:pt idx="19">
                  <c:v>0.96811363615752155</c:v>
                </c:pt>
                <c:pt idx="20">
                  <c:v>0.96811363615752155</c:v>
                </c:pt>
                <c:pt idx="21">
                  <c:v>0.96811363615752155</c:v>
                </c:pt>
                <c:pt idx="22" formatCode="General">
                  <c:v>0.96811363615752155</c:v>
                </c:pt>
                <c:pt idx="23">
                  <c:v>0.9634815134964807</c:v>
                </c:pt>
                <c:pt idx="24" formatCode="General">
                  <c:v>0.9634815134964807</c:v>
                </c:pt>
                <c:pt idx="25">
                  <c:v>0.95884939083543996</c:v>
                </c:pt>
                <c:pt idx="26">
                  <c:v>0.95884939083543996</c:v>
                </c:pt>
                <c:pt idx="27" formatCode="General">
                  <c:v>0.95884939083543996</c:v>
                </c:pt>
                <c:pt idx="28">
                  <c:v>0.95419478214206399</c:v>
                </c:pt>
                <c:pt idx="29">
                  <c:v>0.95419478214206399</c:v>
                </c:pt>
                <c:pt idx="30" formatCode="General">
                  <c:v>0.95419478214206399</c:v>
                </c:pt>
                <c:pt idx="31">
                  <c:v>0.94951735673940685</c:v>
                </c:pt>
                <c:pt idx="32">
                  <c:v>0.94951735673940685</c:v>
                </c:pt>
                <c:pt idx="33">
                  <c:v>0.94951735673940685</c:v>
                </c:pt>
                <c:pt idx="34" formatCode="General">
                  <c:v>0.94951735673940685</c:v>
                </c:pt>
                <c:pt idx="35">
                  <c:v>0.94479338979045457</c:v>
                </c:pt>
                <c:pt idx="36" formatCode="General">
                  <c:v>0.94479338979045457</c:v>
                </c:pt>
                <c:pt idx="37">
                  <c:v>0.9400694228415023</c:v>
                </c:pt>
                <c:pt idx="38">
                  <c:v>0.9400694228415023</c:v>
                </c:pt>
                <c:pt idx="39" formatCode="General">
                  <c:v>0.9400694228415023</c:v>
                </c:pt>
                <c:pt idx="40">
                  <c:v>0.93532159747361587</c:v>
                </c:pt>
                <c:pt idx="41" formatCode="General">
                  <c:v>0.93532159747361587</c:v>
                </c:pt>
                <c:pt idx="42">
                  <c:v>0.93057377210572945</c:v>
                </c:pt>
                <c:pt idx="43" formatCode="General">
                  <c:v>0.93057377210572945</c:v>
                </c:pt>
                <c:pt idx="44">
                  <c:v>0.92582594673784313</c:v>
                </c:pt>
                <c:pt idx="45">
                  <c:v>0.92582594673784313</c:v>
                </c:pt>
                <c:pt idx="46">
                  <c:v>0.92582594673784313</c:v>
                </c:pt>
                <c:pt idx="47">
                  <c:v>0.92582594673784313</c:v>
                </c:pt>
                <c:pt idx="48" formatCode="General">
                  <c:v>0.92582594673784313</c:v>
                </c:pt>
                <c:pt idx="49">
                  <c:v>0.92100393659858348</c:v>
                </c:pt>
                <c:pt idx="50" formatCode="General">
                  <c:v>0.92100393659858348</c:v>
                </c:pt>
                <c:pt idx="51">
                  <c:v>0.91615654745859088</c:v>
                </c:pt>
                <c:pt idx="52" formatCode="General">
                  <c:v>0.91615654745859088</c:v>
                </c:pt>
                <c:pt idx="53">
                  <c:v>0.91130915831859827</c:v>
                </c:pt>
                <c:pt idx="54">
                  <c:v>0.91130915831859827</c:v>
                </c:pt>
                <c:pt idx="55" formatCode="General">
                  <c:v>0.91130915831859827</c:v>
                </c:pt>
                <c:pt idx="56">
                  <c:v>0.90643584731154692</c:v>
                </c:pt>
                <c:pt idx="57" formatCode="General">
                  <c:v>0.90643584731154692</c:v>
                </c:pt>
                <c:pt idx="58">
                  <c:v>0.90156253630449557</c:v>
                </c:pt>
                <c:pt idx="59">
                  <c:v>0.90156253630449557</c:v>
                </c:pt>
                <c:pt idx="60" formatCode="General">
                  <c:v>0.90156253630449557</c:v>
                </c:pt>
                <c:pt idx="61">
                  <c:v>0.89663596506785892</c:v>
                </c:pt>
                <c:pt idx="62">
                  <c:v>0.89663596506785892</c:v>
                </c:pt>
                <c:pt idx="63" formatCode="General">
                  <c:v>0.89663596506785892</c:v>
                </c:pt>
                <c:pt idx="64">
                  <c:v>0.89165465415081524</c:v>
                </c:pt>
                <c:pt idx="65">
                  <c:v>0.89165465415081524</c:v>
                </c:pt>
                <c:pt idx="66">
                  <c:v>0.89165465415081524</c:v>
                </c:pt>
                <c:pt idx="67">
                  <c:v>0.89165465415081524</c:v>
                </c:pt>
                <c:pt idx="68">
                  <c:v>0.89165465415081524</c:v>
                </c:pt>
                <c:pt idx="69">
                  <c:v>0.89165465415081524</c:v>
                </c:pt>
                <c:pt idx="70">
                  <c:v>0.89165465415081524</c:v>
                </c:pt>
                <c:pt idx="71" formatCode="General">
                  <c:v>0.89165465415081524</c:v>
                </c:pt>
                <c:pt idx="72">
                  <c:v>0.88650058100543472</c:v>
                </c:pt>
                <c:pt idx="73">
                  <c:v>0.88650058100543472</c:v>
                </c:pt>
                <c:pt idx="74" formatCode="General">
                  <c:v>0.88650058100543472</c:v>
                </c:pt>
                <c:pt idx="75">
                  <c:v>0.88131636708142624</c:v>
                </c:pt>
                <c:pt idx="76" formatCode="General">
                  <c:v>0.88131636708142624</c:v>
                </c:pt>
                <c:pt idx="77">
                  <c:v>0.87613215315741788</c:v>
                </c:pt>
                <c:pt idx="78">
                  <c:v>0.87613215315741788</c:v>
                </c:pt>
                <c:pt idx="79">
                  <c:v>0.87613215315741788</c:v>
                </c:pt>
                <c:pt idx="80" formatCode="General">
                  <c:v>0.87613215315741788</c:v>
                </c:pt>
                <c:pt idx="81">
                  <c:v>0.87088585283910991</c:v>
                </c:pt>
                <c:pt idx="82" formatCode="General">
                  <c:v>0.87088585283910991</c:v>
                </c:pt>
                <c:pt idx="83">
                  <c:v>0.86563955252080205</c:v>
                </c:pt>
                <c:pt idx="84">
                  <c:v>0.86563955252080205</c:v>
                </c:pt>
                <c:pt idx="85">
                  <c:v>0.86563955252080205</c:v>
                </c:pt>
                <c:pt idx="86" formatCode="General">
                  <c:v>0.86563955252080205</c:v>
                </c:pt>
                <c:pt idx="87">
                  <c:v>0.86032888041944744</c:v>
                </c:pt>
                <c:pt idx="88">
                  <c:v>0.86032888041944744</c:v>
                </c:pt>
                <c:pt idx="89" formatCode="General">
                  <c:v>0.86032888041944744</c:v>
                </c:pt>
                <c:pt idx="90">
                  <c:v>0.85498522277709066</c:v>
                </c:pt>
                <c:pt idx="91">
                  <c:v>0.85498522277709066</c:v>
                </c:pt>
                <c:pt idx="92" formatCode="General">
                  <c:v>0.85498522277709066</c:v>
                </c:pt>
                <c:pt idx="93">
                  <c:v>0.84960795722503346</c:v>
                </c:pt>
                <c:pt idx="94" formatCode="General">
                  <c:v>0.84960795722503346</c:v>
                </c:pt>
                <c:pt idx="95">
                  <c:v>0.84423069167297626</c:v>
                </c:pt>
                <c:pt idx="96" formatCode="General">
                  <c:v>0.84423069167297626</c:v>
                </c:pt>
                <c:pt idx="97">
                  <c:v>0.83885342612091907</c:v>
                </c:pt>
                <c:pt idx="98" formatCode="General">
                  <c:v>0.83885342612091907</c:v>
                </c:pt>
                <c:pt idx="99">
                  <c:v>0.83347616056886187</c:v>
                </c:pt>
                <c:pt idx="100">
                  <c:v>0.83347616056886187</c:v>
                </c:pt>
                <c:pt idx="101" formatCode="General">
                  <c:v>0.83347616056886187</c:v>
                </c:pt>
                <c:pt idx="102">
                  <c:v>0.8280639777080252</c:v>
                </c:pt>
                <c:pt idx="103" formatCode="General">
                  <c:v>0.8280639777080252</c:v>
                </c:pt>
                <c:pt idx="104">
                  <c:v>0.82265179484718842</c:v>
                </c:pt>
                <c:pt idx="105" formatCode="General">
                  <c:v>0.82265179484718842</c:v>
                </c:pt>
                <c:pt idx="106">
                  <c:v>0.81723961198635164</c:v>
                </c:pt>
                <c:pt idx="107" formatCode="General">
                  <c:v>0.81723961198635164</c:v>
                </c:pt>
                <c:pt idx="108">
                  <c:v>0.81182742912551487</c:v>
                </c:pt>
                <c:pt idx="109" formatCode="General">
                  <c:v>0.81182742912551487</c:v>
                </c:pt>
                <c:pt idx="110">
                  <c:v>0.80641524626467809</c:v>
                </c:pt>
                <c:pt idx="111" formatCode="General">
                  <c:v>0.80641524626467809</c:v>
                </c:pt>
                <c:pt idx="112">
                  <c:v>0.80100306340384131</c:v>
                </c:pt>
                <c:pt idx="113" formatCode="General">
                  <c:v>0.80100306340384131</c:v>
                </c:pt>
                <c:pt idx="114">
                  <c:v>0.79559088054300453</c:v>
                </c:pt>
                <c:pt idx="115">
                  <c:v>0.79559088054300453</c:v>
                </c:pt>
                <c:pt idx="116">
                  <c:v>0.79559088054300453</c:v>
                </c:pt>
                <c:pt idx="117" formatCode="General">
                  <c:v>0.79559088054300453</c:v>
                </c:pt>
                <c:pt idx="118">
                  <c:v>0.79006594387256701</c:v>
                </c:pt>
                <c:pt idx="119" formatCode="General">
                  <c:v>0.79006594387256701</c:v>
                </c:pt>
                <c:pt idx="120">
                  <c:v>0.78454100720212949</c:v>
                </c:pt>
                <c:pt idx="121">
                  <c:v>0.78454100720212949</c:v>
                </c:pt>
                <c:pt idx="122" formatCode="General">
                  <c:v>0.78454100720212949</c:v>
                </c:pt>
                <c:pt idx="123">
                  <c:v>0.7789768865836747</c:v>
                </c:pt>
                <c:pt idx="124" formatCode="General">
                  <c:v>0.7789768865836747</c:v>
                </c:pt>
                <c:pt idx="125">
                  <c:v>0.77341276596521991</c:v>
                </c:pt>
                <c:pt idx="126" formatCode="General">
                  <c:v>0.77341276596521991</c:v>
                </c:pt>
                <c:pt idx="127">
                  <c:v>0.76784864534676511</c:v>
                </c:pt>
                <c:pt idx="128" formatCode="General">
                  <c:v>0.76784864534676511</c:v>
                </c:pt>
                <c:pt idx="129">
                  <c:v>0.76228452472831032</c:v>
                </c:pt>
                <c:pt idx="130" formatCode="General">
                  <c:v>0.76228452472831032</c:v>
                </c:pt>
                <c:pt idx="131">
                  <c:v>0.75672040410985553</c:v>
                </c:pt>
                <c:pt idx="132" formatCode="General">
                  <c:v>0.75672040410985553</c:v>
                </c:pt>
                <c:pt idx="133">
                  <c:v>0.75115628349140073</c:v>
                </c:pt>
                <c:pt idx="134">
                  <c:v>0.75115628349140073</c:v>
                </c:pt>
                <c:pt idx="135" formatCode="General">
                  <c:v>0.75115628349140073</c:v>
                </c:pt>
                <c:pt idx="136">
                  <c:v>0.74555063958474843</c:v>
                </c:pt>
                <c:pt idx="137">
                  <c:v>0.74555063958474843</c:v>
                </c:pt>
                <c:pt idx="138" formatCode="General">
                  <c:v>0.74555063958474843</c:v>
                </c:pt>
                <c:pt idx="139">
                  <c:v>0.73990252867880335</c:v>
                </c:pt>
                <c:pt idx="140">
                  <c:v>0.73990252867880335</c:v>
                </c:pt>
                <c:pt idx="141">
                  <c:v>0.73990252867880335</c:v>
                </c:pt>
                <c:pt idx="142">
                  <c:v>0.73990252867880335</c:v>
                </c:pt>
                <c:pt idx="143">
                  <c:v>0.73990252867880335</c:v>
                </c:pt>
                <c:pt idx="144">
                  <c:v>0.73990252867880335</c:v>
                </c:pt>
                <c:pt idx="145" formatCode="General">
                  <c:v>0.73990252867880335</c:v>
                </c:pt>
                <c:pt idx="146">
                  <c:v>0.73403028638770174</c:v>
                </c:pt>
                <c:pt idx="147">
                  <c:v>0.73403028638770174</c:v>
                </c:pt>
                <c:pt idx="148" formatCode="General">
                  <c:v>0.73403028638770174</c:v>
                </c:pt>
                <c:pt idx="149">
                  <c:v>0.72811068730392992</c:v>
                </c:pt>
                <c:pt idx="150" formatCode="General">
                  <c:v>0.72811068730392992</c:v>
                </c:pt>
                <c:pt idx="151">
                  <c:v>0.7221910882201581</c:v>
                </c:pt>
                <c:pt idx="152" formatCode="General">
                  <c:v>0.7221910882201581</c:v>
                </c:pt>
                <c:pt idx="153">
                  <c:v>0.71627148913638627</c:v>
                </c:pt>
                <c:pt idx="154" formatCode="General">
                  <c:v>0.71627148913638627</c:v>
                </c:pt>
                <c:pt idx="155">
                  <c:v>0.71035189005261445</c:v>
                </c:pt>
                <c:pt idx="156" formatCode="General">
                  <c:v>0.71035189005261445</c:v>
                </c:pt>
                <c:pt idx="157">
                  <c:v>0.70443229096884263</c:v>
                </c:pt>
                <c:pt idx="158" formatCode="General">
                  <c:v>0.70443229096884263</c:v>
                </c:pt>
                <c:pt idx="159">
                  <c:v>0.69851269188507081</c:v>
                </c:pt>
                <c:pt idx="160" formatCode="General">
                  <c:v>0.69851269188507081</c:v>
                </c:pt>
                <c:pt idx="161">
                  <c:v>0.69259309280129899</c:v>
                </c:pt>
                <c:pt idx="162" formatCode="General">
                  <c:v>0.69259309280129899</c:v>
                </c:pt>
                <c:pt idx="163">
                  <c:v>0.68667349371752717</c:v>
                </c:pt>
                <c:pt idx="164" formatCode="General">
                  <c:v>0.68667349371752717</c:v>
                </c:pt>
                <c:pt idx="165">
                  <c:v>0.68075389463375546</c:v>
                </c:pt>
                <c:pt idx="166" formatCode="General">
                  <c:v>0.68075389463375546</c:v>
                </c:pt>
                <c:pt idx="167">
                  <c:v>0.67483429554998375</c:v>
                </c:pt>
                <c:pt idx="168" formatCode="General">
                  <c:v>0.67483429554998375</c:v>
                </c:pt>
                <c:pt idx="169">
                  <c:v>0.66891469646621193</c:v>
                </c:pt>
                <c:pt idx="170">
                  <c:v>0.66891469646621193</c:v>
                </c:pt>
                <c:pt idx="171">
                  <c:v>0.66891469646621193</c:v>
                </c:pt>
                <c:pt idx="172" formatCode="General">
                  <c:v>0.66891469646621193</c:v>
                </c:pt>
                <c:pt idx="173">
                  <c:v>0.66288843793948926</c:v>
                </c:pt>
                <c:pt idx="174" formatCode="General">
                  <c:v>0.66288843793948926</c:v>
                </c:pt>
                <c:pt idx="175">
                  <c:v>0.6568621794127667</c:v>
                </c:pt>
                <c:pt idx="176" formatCode="General">
                  <c:v>0.6568621794127667</c:v>
                </c:pt>
                <c:pt idx="177">
                  <c:v>0.65083592088604414</c:v>
                </c:pt>
                <c:pt idx="178">
                  <c:v>0.65083592088604414</c:v>
                </c:pt>
                <c:pt idx="179" formatCode="General">
                  <c:v>0.65083592088604414</c:v>
                </c:pt>
                <c:pt idx="180">
                  <c:v>0.63867076348630503</c:v>
                </c:pt>
                <c:pt idx="181" formatCode="General">
                  <c:v>0.63867076348630503</c:v>
                </c:pt>
                <c:pt idx="182">
                  <c:v>0.63258818478643553</c:v>
                </c:pt>
                <c:pt idx="183" formatCode="General">
                  <c:v>0.63258818478643553</c:v>
                </c:pt>
                <c:pt idx="184">
                  <c:v>0.62650560608656602</c:v>
                </c:pt>
                <c:pt idx="185" formatCode="General">
                  <c:v>0.62650560608656602</c:v>
                </c:pt>
                <c:pt idx="186">
                  <c:v>0.62042302738669641</c:v>
                </c:pt>
                <c:pt idx="187">
                  <c:v>0.62042302738669641</c:v>
                </c:pt>
                <c:pt idx="188" formatCode="General">
                  <c:v>0.62042302738669641</c:v>
                </c:pt>
                <c:pt idx="189">
                  <c:v>0.61428022513534297</c:v>
                </c:pt>
                <c:pt idx="190" formatCode="General">
                  <c:v>0.61428022513534297</c:v>
                </c:pt>
                <c:pt idx="191">
                  <c:v>0.60813742288398953</c:v>
                </c:pt>
                <c:pt idx="192">
                  <c:v>0.60813742288398953</c:v>
                </c:pt>
                <c:pt idx="193">
                  <c:v>0.60813742288398953</c:v>
                </c:pt>
                <c:pt idx="194" formatCode="General">
                  <c:v>0.60813742288398953</c:v>
                </c:pt>
                <c:pt idx="195">
                  <c:v>0.60186796491611338</c:v>
                </c:pt>
                <c:pt idx="196">
                  <c:v>0.60186796491611338</c:v>
                </c:pt>
                <c:pt idx="197" formatCode="General">
                  <c:v>0.60186796491611338</c:v>
                </c:pt>
                <c:pt idx="198">
                  <c:v>0.59553251265383844</c:v>
                </c:pt>
                <c:pt idx="199" formatCode="General">
                  <c:v>0.59553251265383844</c:v>
                </c:pt>
                <c:pt idx="200">
                  <c:v>0.58919706039156361</c:v>
                </c:pt>
                <c:pt idx="201" formatCode="General">
                  <c:v>0.58919706039156361</c:v>
                </c:pt>
                <c:pt idx="202">
                  <c:v>0.58286160812928878</c:v>
                </c:pt>
                <c:pt idx="203" formatCode="General">
                  <c:v>0.58286160812928878</c:v>
                </c:pt>
                <c:pt idx="204">
                  <c:v>0.57652615586701383</c:v>
                </c:pt>
                <c:pt idx="205" formatCode="General">
                  <c:v>0.57652615586701383</c:v>
                </c:pt>
                <c:pt idx="206">
                  <c:v>0.570190703604739</c:v>
                </c:pt>
                <c:pt idx="207" formatCode="General">
                  <c:v>0.570190703604739</c:v>
                </c:pt>
                <c:pt idx="208">
                  <c:v>0.56385525134246417</c:v>
                </c:pt>
                <c:pt idx="209" formatCode="General">
                  <c:v>0.56385525134246417</c:v>
                </c:pt>
                <c:pt idx="210">
                  <c:v>0.55751979908018923</c:v>
                </c:pt>
                <c:pt idx="211" formatCode="General">
                  <c:v>0.55751979908018923</c:v>
                </c:pt>
                <c:pt idx="212">
                  <c:v>0.55118434681791439</c:v>
                </c:pt>
                <c:pt idx="213" formatCode="General">
                  <c:v>0.55118434681791439</c:v>
                </c:pt>
                <c:pt idx="214">
                  <c:v>0.54484889455563956</c:v>
                </c:pt>
                <c:pt idx="215" formatCode="General">
                  <c:v>0.54484889455563956</c:v>
                </c:pt>
                <c:pt idx="216">
                  <c:v>0.53851344229336462</c:v>
                </c:pt>
                <c:pt idx="217">
                  <c:v>0.53851344229336462</c:v>
                </c:pt>
                <c:pt idx="218" formatCode="General">
                  <c:v>0.53851344229336462</c:v>
                </c:pt>
                <c:pt idx="219">
                  <c:v>0.53210256798034838</c:v>
                </c:pt>
                <c:pt idx="220">
                  <c:v>0.53210256798034838</c:v>
                </c:pt>
                <c:pt idx="221" formatCode="General">
                  <c:v>0.53210256798034838</c:v>
                </c:pt>
                <c:pt idx="222">
                  <c:v>0.52561351227327091</c:v>
                </c:pt>
                <c:pt idx="223" formatCode="General">
                  <c:v>0.52561351227327091</c:v>
                </c:pt>
                <c:pt idx="224">
                  <c:v>0.51912445656619344</c:v>
                </c:pt>
                <c:pt idx="225" formatCode="General">
                  <c:v>0.51912445656619344</c:v>
                </c:pt>
                <c:pt idx="226">
                  <c:v>0.51263540085911607</c:v>
                </c:pt>
                <c:pt idx="227">
                  <c:v>0.51263540085911607</c:v>
                </c:pt>
                <c:pt idx="228" formatCode="General">
                  <c:v>0.51263540085911607</c:v>
                </c:pt>
                <c:pt idx="229">
                  <c:v>0.50606315213015307</c:v>
                </c:pt>
                <c:pt idx="230">
                  <c:v>0.50606315213015307</c:v>
                </c:pt>
                <c:pt idx="231">
                  <c:v>0.50606315213015307</c:v>
                </c:pt>
                <c:pt idx="232" formatCode="General">
                  <c:v>0.50606315213015307</c:v>
                </c:pt>
                <c:pt idx="233">
                  <c:v>0.49931564343508439</c:v>
                </c:pt>
                <c:pt idx="234" formatCode="General">
                  <c:v>0.49931564343508439</c:v>
                </c:pt>
                <c:pt idx="235">
                  <c:v>0.49256813474001571</c:v>
                </c:pt>
                <c:pt idx="236" formatCode="General">
                  <c:v>0.49256813474001571</c:v>
                </c:pt>
                <c:pt idx="237">
                  <c:v>0.48582062604494697</c:v>
                </c:pt>
                <c:pt idx="238" formatCode="General">
                  <c:v>0.48582062604494697</c:v>
                </c:pt>
                <c:pt idx="239">
                  <c:v>0.47907311734987829</c:v>
                </c:pt>
                <c:pt idx="240">
                  <c:v>0.47907311734987829</c:v>
                </c:pt>
                <c:pt idx="241" formatCode="General">
                  <c:v>0.47907311734987829</c:v>
                </c:pt>
                <c:pt idx="242">
                  <c:v>0.4722292156734515</c:v>
                </c:pt>
                <c:pt idx="243" formatCode="General">
                  <c:v>0.4722292156734515</c:v>
                </c:pt>
                <c:pt idx="244">
                  <c:v>0.46538531399702471</c:v>
                </c:pt>
                <c:pt idx="245" formatCode="General">
                  <c:v>0.46538531399702471</c:v>
                </c:pt>
                <c:pt idx="246">
                  <c:v>0.45854141232059792</c:v>
                </c:pt>
                <c:pt idx="247" formatCode="General">
                  <c:v>0.45854141232059792</c:v>
                </c:pt>
                <c:pt idx="248">
                  <c:v>0.45169751064417107</c:v>
                </c:pt>
                <c:pt idx="249" formatCode="General">
                  <c:v>0.45169751064417107</c:v>
                </c:pt>
                <c:pt idx="250">
                  <c:v>0.44485360896774423</c:v>
                </c:pt>
                <c:pt idx="251" formatCode="General">
                  <c:v>0.44485360896774423</c:v>
                </c:pt>
                <c:pt idx="252">
                  <c:v>0.43800970729131744</c:v>
                </c:pt>
                <c:pt idx="253" formatCode="General">
                  <c:v>0.43800970729131744</c:v>
                </c:pt>
                <c:pt idx="254">
                  <c:v>0.4311658056148906</c:v>
                </c:pt>
                <c:pt idx="255" formatCode="General">
                  <c:v>0.4311658056148906</c:v>
                </c:pt>
                <c:pt idx="256">
                  <c:v>0.42432190393846375</c:v>
                </c:pt>
                <c:pt idx="257" formatCode="General">
                  <c:v>0.42432190393846375</c:v>
                </c:pt>
                <c:pt idx="258">
                  <c:v>0.41747800226203691</c:v>
                </c:pt>
                <c:pt idx="259" formatCode="General">
                  <c:v>0.41747800226203691</c:v>
                </c:pt>
                <c:pt idx="260">
                  <c:v>0.41063410058561006</c:v>
                </c:pt>
                <c:pt idx="261">
                  <c:v>0.41063410058561006</c:v>
                </c:pt>
                <c:pt idx="262" formatCode="General">
                  <c:v>0.41063410058561006</c:v>
                </c:pt>
                <c:pt idx="263">
                  <c:v>0.40367420057568448</c:v>
                </c:pt>
                <c:pt idx="264" formatCode="General">
                  <c:v>0.40367420057568448</c:v>
                </c:pt>
                <c:pt idx="265">
                  <c:v>0.39671430056575885</c:v>
                </c:pt>
                <c:pt idx="266">
                  <c:v>0.39671430056575885</c:v>
                </c:pt>
                <c:pt idx="267" formatCode="General">
                  <c:v>0.39671430056575885</c:v>
                </c:pt>
                <c:pt idx="268">
                  <c:v>0.38963011662708458</c:v>
                </c:pt>
                <c:pt idx="269" formatCode="General">
                  <c:v>0.38963011662708458</c:v>
                </c:pt>
                <c:pt idx="270">
                  <c:v>0.38254593268841031</c:v>
                </c:pt>
                <c:pt idx="271" formatCode="General">
                  <c:v>0.38254593268841031</c:v>
                </c:pt>
                <c:pt idx="272">
                  <c:v>0.37546174874973604</c:v>
                </c:pt>
                <c:pt idx="273" formatCode="General">
                  <c:v>0.37546174874973604</c:v>
                </c:pt>
                <c:pt idx="274">
                  <c:v>0.36837756481106176</c:v>
                </c:pt>
                <c:pt idx="275" formatCode="General">
                  <c:v>0.36837756481106176</c:v>
                </c:pt>
                <c:pt idx="276">
                  <c:v>0.36129338087238749</c:v>
                </c:pt>
                <c:pt idx="277">
                  <c:v>0.36129338087238749</c:v>
                </c:pt>
                <c:pt idx="278">
                  <c:v>0.36129338087238749</c:v>
                </c:pt>
                <c:pt idx="279" formatCode="General">
                  <c:v>0.36129338087238749</c:v>
                </c:pt>
                <c:pt idx="280">
                  <c:v>0.35392004656886938</c:v>
                </c:pt>
                <c:pt idx="281" formatCode="General">
                  <c:v>0.35392004656886938</c:v>
                </c:pt>
                <c:pt idx="282">
                  <c:v>0.34654671226535128</c:v>
                </c:pt>
                <c:pt idx="283">
                  <c:v>0.34654671226535128</c:v>
                </c:pt>
                <c:pt idx="284" formatCode="General">
                  <c:v>0.34654671226535128</c:v>
                </c:pt>
                <c:pt idx="285">
                  <c:v>0.33901308808566971</c:v>
                </c:pt>
                <c:pt idx="286" formatCode="General">
                  <c:v>0.33901308808566971</c:v>
                </c:pt>
                <c:pt idx="287">
                  <c:v>0.33147946390598815</c:v>
                </c:pt>
                <c:pt idx="288">
                  <c:v>0.33147946390598815</c:v>
                </c:pt>
                <c:pt idx="289">
                  <c:v>0.33147946390598815</c:v>
                </c:pt>
                <c:pt idx="290">
                  <c:v>0.33147946390598815</c:v>
                </c:pt>
                <c:pt idx="291">
                  <c:v>0.33147946390598815</c:v>
                </c:pt>
                <c:pt idx="292" formatCode="General">
                  <c:v>0.33147946390598815</c:v>
                </c:pt>
                <c:pt idx="293">
                  <c:v>0.32319247730833844</c:v>
                </c:pt>
                <c:pt idx="294" formatCode="General">
                  <c:v>0.32319247730833844</c:v>
                </c:pt>
                <c:pt idx="295">
                  <c:v>0.31490549071068874</c:v>
                </c:pt>
                <c:pt idx="296">
                  <c:v>0.31490549071068874</c:v>
                </c:pt>
                <c:pt idx="297" formatCode="General">
                  <c:v>0.31490549071068874</c:v>
                </c:pt>
                <c:pt idx="298">
                  <c:v>0.30639453150229179</c:v>
                </c:pt>
                <c:pt idx="299" formatCode="General">
                  <c:v>0.30639453150229179</c:v>
                </c:pt>
                <c:pt idx="300">
                  <c:v>0.29788357229389478</c:v>
                </c:pt>
                <c:pt idx="301">
                  <c:v>0.29788357229389478</c:v>
                </c:pt>
                <c:pt idx="302">
                  <c:v>0.29788357229389478</c:v>
                </c:pt>
                <c:pt idx="303">
                  <c:v>0.29788357229389478</c:v>
                </c:pt>
                <c:pt idx="304" formatCode="General">
                  <c:v>0.29788357229389478</c:v>
                </c:pt>
                <c:pt idx="305">
                  <c:v>0.28857471065971058</c:v>
                </c:pt>
                <c:pt idx="306" formatCode="General">
                  <c:v>0.28857471065971058</c:v>
                </c:pt>
                <c:pt idx="307">
                  <c:v>0.27926584902552637</c:v>
                </c:pt>
                <c:pt idx="308" formatCode="General">
                  <c:v>0.27926584902552637</c:v>
                </c:pt>
                <c:pt idx="309">
                  <c:v>0.26995698739134216</c:v>
                </c:pt>
                <c:pt idx="310">
                  <c:v>0.26995698739134216</c:v>
                </c:pt>
                <c:pt idx="311" formatCode="General">
                  <c:v>0.26995698739134216</c:v>
                </c:pt>
                <c:pt idx="312">
                  <c:v>0.26031566641307996</c:v>
                </c:pt>
                <c:pt idx="313" formatCode="General">
                  <c:v>0.26031566641307996</c:v>
                </c:pt>
                <c:pt idx="314">
                  <c:v>0.2506743454348177</c:v>
                </c:pt>
                <c:pt idx="315" formatCode="General">
                  <c:v>0.2506743454348177</c:v>
                </c:pt>
                <c:pt idx="316">
                  <c:v>0.2410330244565555</c:v>
                </c:pt>
                <c:pt idx="317" formatCode="General">
                  <c:v>0.2410330244565555</c:v>
                </c:pt>
                <c:pt idx="318">
                  <c:v>0.23139170347829327</c:v>
                </c:pt>
                <c:pt idx="319">
                  <c:v>0.23139170347829327</c:v>
                </c:pt>
                <c:pt idx="320" formatCode="General">
                  <c:v>0.23139170347829327</c:v>
                </c:pt>
                <c:pt idx="321">
                  <c:v>0.22133119463141096</c:v>
                </c:pt>
                <c:pt idx="322">
                  <c:v>0.22133119463141096</c:v>
                </c:pt>
                <c:pt idx="323">
                  <c:v>0.22133119463141096</c:v>
                </c:pt>
                <c:pt idx="324" formatCode="General">
                  <c:v>0.22133119463141096</c:v>
                </c:pt>
                <c:pt idx="325">
                  <c:v>0.2102646348998404</c:v>
                </c:pt>
                <c:pt idx="326" formatCode="General">
                  <c:v>0.2102646348998404</c:v>
                </c:pt>
                <c:pt idx="327">
                  <c:v>0.19919807516826984</c:v>
                </c:pt>
                <c:pt idx="328" formatCode="General">
                  <c:v>0.19919807516826984</c:v>
                </c:pt>
                <c:pt idx="329">
                  <c:v>0.18813151543669929</c:v>
                </c:pt>
                <c:pt idx="330">
                  <c:v>0.18813151543669929</c:v>
                </c:pt>
                <c:pt idx="331" formatCode="General">
                  <c:v>0.18813151543669929</c:v>
                </c:pt>
                <c:pt idx="332">
                  <c:v>0.17637329572190558</c:v>
                </c:pt>
                <c:pt idx="333">
                  <c:v>0.17637329572190558</c:v>
                </c:pt>
                <c:pt idx="334" formatCode="General">
                  <c:v>0.17637329572190558</c:v>
                </c:pt>
                <c:pt idx="335">
                  <c:v>0.16377520317034089</c:v>
                </c:pt>
                <c:pt idx="336" formatCode="General">
                  <c:v>0.16377520317034089</c:v>
                </c:pt>
                <c:pt idx="337">
                  <c:v>0.1511771106187762</c:v>
                </c:pt>
                <c:pt idx="338">
                  <c:v>0.1511771106187762</c:v>
                </c:pt>
                <c:pt idx="339" formatCode="General">
                  <c:v>0.1511771106187762</c:v>
                </c:pt>
                <c:pt idx="340">
                  <c:v>0.13743373692616018</c:v>
                </c:pt>
                <c:pt idx="341">
                  <c:v>0.13743373692616018</c:v>
                </c:pt>
                <c:pt idx="342" formatCode="General">
                  <c:v>0.13743373692616018</c:v>
                </c:pt>
                <c:pt idx="343">
                  <c:v>0.12216332171214238</c:v>
                </c:pt>
                <c:pt idx="344">
                  <c:v>0.12216332171214238</c:v>
                </c:pt>
                <c:pt idx="345" formatCode="General">
                  <c:v>0.12216332171214238</c:v>
                </c:pt>
                <c:pt idx="346">
                  <c:v>0.10471141861040775</c:v>
                </c:pt>
                <c:pt idx="347">
                  <c:v>0.10471141861040775</c:v>
                </c:pt>
                <c:pt idx="348">
                  <c:v>0.10471141861040775</c:v>
                </c:pt>
                <c:pt idx="349" formatCode="General">
                  <c:v>0.10471141861040775</c:v>
                </c:pt>
                <c:pt idx="350">
                  <c:v>7.8533563957805808E-2</c:v>
                </c:pt>
                <c:pt idx="351">
                  <c:v>7.8533563957805808E-2</c:v>
                </c:pt>
                <c:pt idx="352" formatCode="General">
                  <c:v>7.8533563957805808E-2</c:v>
                </c:pt>
                <c:pt idx="353">
                  <c:v>3.9266781978902904E-2</c:v>
                </c:pt>
                <c:pt idx="354">
                  <c:v>3.9266781978902904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970-4FD4-9EA3-8E64117A66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8812280"/>
        <c:axId val="338809928"/>
      </c:scatterChart>
      <c:valAx>
        <c:axId val="338812280"/>
        <c:scaling>
          <c:orientation val="minMax"/>
          <c:max val="5475"/>
        </c:scaling>
        <c:delete val="0"/>
        <c:axPos val="b"/>
        <c:title>
          <c:tx>
            <c:rich>
              <a:bodyPr/>
              <a:lstStyle/>
              <a:p>
                <a:pPr>
                  <a:defRPr lang="ja-JP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1800" b="1" i="0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low-up (years)</a:t>
                </a:r>
                <a:endParaRPr lang="ja-JP" altLang="ja-JP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>
                <a:solidFill>
                  <a:schemeClr val="bg1"/>
                </a:solidFill>
              </a:defRPr>
            </a:pPr>
            <a:endParaRPr lang="ja-JP"/>
          </a:p>
        </c:txPr>
        <c:crossAx val="338809928"/>
        <c:crosses val="autoZero"/>
        <c:crossBetween val="midCat"/>
        <c:majorUnit val="365"/>
      </c:valAx>
      <c:valAx>
        <c:axId val="338809928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lang="ja-JP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1800" b="1" i="0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rvival (%)</a:t>
                </a:r>
                <a:endParaRPr lang="ja-JP" altLang="ja-JP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txPr>
          <a:bodyPr/>
          <a:lstStyle/>
          <a:p>
            <a:pPr>
              <a:defRPr lang="ja-JP" sz="1600">
                <a:solidFill>
                  <a:schemeClr val="bg1"/>
                </a:solidFill>
              </a:defRPr>
            </a:pPr>
            <a:endParaRPr lang="ja-JP"/>
          </a:p>
        </c:txPr>
        <c:crossAx val="338812280"/>
        <c:crosses val="autoZero"/>
        <c:crossBetween val="midCat"/>
        <c:majorUnit val="0.2"/>
      </c:valAx>
      <c:spPr>
        <a:noFill/>
      </c:spPr>
    </c:plotArea>
    <c:legend>
      <c:legendPos val="r"/>
      <c:layout>
        <c:manualLayout>
          <c:xMode val="edge"/>
          <c:yMode val="edge"/>
          <c:x val="0.66719455749158918"/>
          <c:y val="0.16867285559474066"/>
          <c:w val="0.20606113779347709"/>
          <c:h val="0.14562275339793881"/>
        </c:manualLayout>
      </c:layout>
      <c:overlay val="1"/>
      <c:txPr>
        <a:bodyPr/>
        <a:lstStyle/>
        <a:p>
          <a:pPr>
            <a:defRPr lang="ja-JP" sz="18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614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401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4119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536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081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928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081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0175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6949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54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474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399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グラフ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2480827"/>
              </p:ext>
            </p:extLst>
          </p:nvPr>
        </p:nvGraphicFramePr>
        <p:xfrm>
          <a:off x="346229" y="858125"/>
          <a:ext cx="11532093" cy="5248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8485524" y="3264951"/>
            <a:ext cx="27847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D score &lt;7 vs. 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≧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og-rank test,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017) 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843381" y="867003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843382" y="167635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843381" y="2464476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43381" y="326495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43379" y="4071795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843379" y="4863385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453201" y="5043110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124580" y="504550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084552" y="504241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781825" y="504550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807608" y="5038658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487117" y="5039306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164029" y="5039954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838178" y="5040690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529339" y="5041292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7201268" y="5041532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871904" y="5045825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553638" y="504550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9237031" y="504550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9913405" y="5045825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0595139" y="5038607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1275756" y="5038607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49939" y="286937"/>
            <a:ext cx="1216240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2. Cumulative 15-year survival rates by MELD score in patients with decompensated HCV-related cirrhosis without HCC (N=379).</a:t>
            </a:r>
            <a:endParaRPr lang="ja-JP" altLang="ja-JP" sz="1400" dirty="0">
              <a:effectLst/>
              <a:latin typeface="ＭＳ 明朝" panose="02020609040205080304" pitchFamily="17" charset="-128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7222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0</TotalTime>
  <Words>66</Words>
  <Application>Microsoft Office PowerPoint</Application>
  <PresentationFormat>ワイド画面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nshun</dc:creator>
  <cp:lastModifiedBy>俊一郎 藤山</cp:lastModifiedBy>
  <cp:revision>67</cp:revision>
  <cp:lastPrinted>2020-10-22T11:43:42Z</cp:lastPrinted>
  <dcterms:created xsi:type="dcterms:W3CDTF">2019-10-17T11:56:30Z</dcterms:created>
  <dcterms:modified xsi:type="dcterms:W3CDTF">2021-03-18T11:17:52Z</dcterms:modified>
</cp:coreProperties>
</file>